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13716000" cy="210312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AK" userId="S::kaynakat@ucmail.uc.edu::e30822f5-f881-493f-bf88-3d523b0e27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2" autoAdjust="0"/>
    <p:restoredTop sz="97437" autoAdjust="0"/>
  </p:normalViewPr>
  <p:slideViewPr>
    <p:cSldViewPr snapToGrid="0">
      <p:cViewPr>
        <p:scale>
          <a:sx n="75" d="100"/>
          <a:sy n="75" d="100"/>
        </p:scale>
        <p:origin x="3328" y="-2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E30A1243-BD87-4BF6-BC16-7D8169E3357D}"/>
    <pc:docChg chg="modSld">
      <pc:chgData name="Kaynak, Ahmet (kaynakat)" userId="e30822f5-f881-493f-bf88-3d523b0e27a6" providerId="ADAL" clId="{E30A1243-BD87-4BF6-BC16-7D8169E3357D}" dt="2025-01-27T17:34:36.014" v="53" actId="20577"/>
      <pc:docMkLst>
        <pc:docMk/>
      </pc:docMkLst>
      <pc:sldChg chg="modSp mod">
        <pc:chgData name="Kaynak, Ahmet (kaynakat)" userId="e30822f5-f881-493f-bf88-3d523b0e27a6" providerId="ADAL" clId="{E30A1243-BD87-4BF6-BC16-7D8169E3357D}" dt="2025-01-27T17:34:36.014" v="53" actId="20577"/>
        <pc:sldMkLst>
          <pc:docMk/>
          <pc:sldMk cId="2321588582" sldId="256"/>
        </pc:sldMkLst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36" creationId="{549A6FE1-D0F7-B44F-79F3-8CDB8350DA55}"/>
          </ac:spMkLst>
        </pc:spChg>
        <pc:spChg chg="mod">
          <ac:chgData name="Kaynak, Ahmet (kaynakat)" userId="e30822f5-f881-493f-bf88-3d523b0e27a6" providerId="ADAL" clId="{E30A1243-BD87-4BF6-BC16-7D8169E3357D}" dt="2025-01-27T17:34:36.014" v="53" actId="20577"/>
          <ac:spMkLst>
            <pc:docMk/>
            <pc:sldMk cId="2321588582" sldId="256"/>
            <ac:spMk id="38" creationId="{E783353C-9D23-FF7F-A5D2-3F0DCE4F3377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04" creationId="{CC5B7EC1-32E8-C1BB-7EBC-35B83F7215FA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17" creationId="{C7499FCE-97EC-D680-4605-6A258ACA6ED1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47" creationId="{F0DDA637-E77D-08DF-37C8-435C7524B606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85" creationId="{D7CD1048-D12F-C5E0-46C5-2CE286706897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87" creationId="{12DB2290-D8E9-C1CD-AF32-D05DC7C4A7BC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91" creationId="{98B7B51D-6DA0-27DA-7306-9DCD608C6B3B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92" creationId="{B4FA88E2-4F29-4457-3F2C-FDDDABFC00F1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195" creationId="{85537EA1-10F2-CACF-74D6-BC32424D1B0A}"/>
          </ac:spMkLst>
        </pc:spChg>
        <pc:spChg chg="mod">
          <ac:chgData name="Kaynak, Ahmet (kaynakat)" userId="e30822f5-f881-493f-bf88-3d523b0e27a6" providerId="ADAL" clId="{E30A1243-BD87-4BF6-BC16-7D8169E3357D}" dt="2025-01-27T17:30:40.961" v="2" actId="1076"/>
          <ac:spMkLst>
            <pc:docMk/>
            <pc:sldMk cId="2321588582" sldId="256"/>
            <ac:spMk id="200" creationId="{6D80C038-6C6F-65A6-2EE7-5FB085BC506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9880CF3-FDA2-4B89-AED2-455CAC02616E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82850" y="1162050"/>
            <a:ext cx="2044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8CE92EE-02C9-424A-AD7D-2D3AF1FB3C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042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1pPr>
    <a:lvl2pPr marL="767943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2pPr>
    <a:lvl3pPr marL="153588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3pPr>
    <a:lvl4pPr marL="230382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4pPr>
    <a:lvl5pPr marL="3071769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5pPr>
    <a:lvl6pPr marL="3839712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6pPr>
    <a:lvl7pPr marL="4607655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7pPr>
    <a:lvl8pPr marL="5375597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8pPr>
    <a:lvl9pPr marL="614354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441913"/>
            <a:ext cx="11658600" cy="732197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11046250"/>
            <a:ext cx="10287000" cy="5077670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39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477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1119717"/>
            <a:ext cx="2957513" cy="17822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1119717"/>
            <a:ext cx="8701088" cy="17822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112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69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5243201"/>
            <a:ext cx="11830050" cy="8748393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14074358"/>
            <a:ext cx="11830050" cy="4600573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>
                    <a:tint val="82000"/>
                  </a:schemeClr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82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82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53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5598583"/>
            <a:ext cx="582930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5598583"/>
            <a:ext cx="582930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64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119721"/>
            <a:ext cx="11830050" cy="406506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5155567"/>
            <a:ext cx="5802510" cy="2526663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7682230"/>
            <a:ext cx="5802510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5155567"/>
            <a:ext cx="5831087" cy="2526663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7682230"/>
            <a:ext cx="5831087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30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377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107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402080"/>
            <a:ext cx="4423767" cy="490728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3028108"/>
            <a:ext cx="6943725" cy="14945783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309360"/>
            <a:ext cx="4423767" cy="11688870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532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402080"/>
            <a:ext cx="4423767" cy="490728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3028108"/>
            <a:ext cx="6943725" cy="14945783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309360"/>
            <a:ext cx="4423767" cy="11688870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78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1119721"/>
            <a:ext cx="11830050" cy="40650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5598583"/>
            <a:ext cx="11830050" cy="133441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9492811"/>
            <a:ext cx="308610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9492811"/>
            <a:ext cx="462915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9492811"/>
            <a:ext cx="308610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611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.tif"/><Relationship Id="rId5" Type="http://schemas.openxmlformats.org/officeDocument/2006/relationships/image" Target="../media/image4.png"/><Relationship Id="rId10" Type="http://schemas.microsoft.com/office/2007/relationships/hdphoto" Target="../media/hdphoto3.wdp"/><Relationship Id="rId4" Type="http://schemas.openxmlformats.org/officeDocument/2006/relationships/image" Target="../media/image3.tiff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549A6FE1-D0F7-B44F-79F3-8CDB8350DA55}"/>
              </a:ext>
            </a:extLst>
          </p:cNvPr>
          <p:cNvSpPr txBox="1"/>
          <p:nvPr/>
        </p:nvSpPr>
        <p:spPr>
          <a:xfrm>
            <a:off x="521175" y="451387"/>
            <a:ext cx="16353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, left pane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783353C-9D23-FF7F-A5D2-3F0DCE4F3377}"/>
              </a:ext>
            </a:extLst>
          </p:cNvPr>
          <p:cNvSpPr txBox="1"/>
          <p:nvPr/>
        </p:nvSpPr>
        <p:spPr>
          <a:xfrm>
            <a:off x="338419" y="15836007"/>
            <a:ext cx="13144117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4: Western blotting evaluation of pT636-Hsp70, Hsp70, Actin, Pan-</a:t>
            </a:r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APDH in cancer cells and cancer cell-secreted EMD-CM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ting was performed using anti-pT636-Hsp70 antibody (a gift from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ivoj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jtesek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etr Muller) 1:300, anti-Hsp70 antibody (Santa Cruz Biotechnology, TX) 1:500, anti-actin antibody (Cell Signaling Technology, MA) 1:1000 as a housekeeping protein 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el). Western blotting was performed using anti-Pan-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 (Santa Cruz Biotechnology, TX) 1:1000, anti-Hsp70 antibody (Santa Cruz Biotechnology, TX) 1:500, and anti-GAPDH antibody (Cell Signaling Technology, MA) 1:1000 as a housekeeping protein 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el). Results confirmed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reonine 636 phosphorylated Hsp70 expression in both cell lysates and cancer cell-secreted EMD-CMs, whereas tyrosine phosphorylated Hsp70 expression was confirmed in cancer </a:t>
            </a:r>
            <a:r>
              <a:rPr lang="en-US" sz="200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-secreted EMD-CMs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nly. 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ting was performed using an anti-Pan-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 (Santa Cruz Biotechnology, TX) 1:1000, and the anti-pT636-Hsp70 antibody (a gift from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ivoj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jtesek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etr Muller) 1:300. Results confirmed the expression of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reonine 636 and tyrosine phosphorylated Hsp70 in both cell lysates and cancer cell-secreted EMD-CMs.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FE3A7376-78FE-A737-1A81-24B8A6EDC8B2}"/>
              </a:ext>
            </a:extLst>
          </p:cNvPr>
          <p:cNvGrpSpPr/>
          <p:nvPr/>
        </p:nvGrpSpPr>
        <p:grpSpPr>
          <a:xfrm>
            <a:off x="302276" y="1258054"/>
            <a:ext cx="13693915" cy="4047548"/>
            <a:chOff x="198626" y="882662"/>
            <a:chExt cx="13693915" cy="4047548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1177835-8DD9-A658-D109-E42B81D5A15C}"/>
                </a:ext>
              </a:extLst>
            </p:cNvPr>
            <p:cNvSpPr txBox="1"/>
            <p:nvPr/>
          </p:nvSpPr>
          <p:spPr>
            <a:xfrm>
              <a:off x="378600" y="891225"/>
              <a:ext cx="3161341" cy="61555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just"/>
              <a:r>
                <a:rPr lang="en-US" sz="2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70 </a:t>
              </a:r>
              <a:r>
                <a:rPr lang="en-US" sz="20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osphothreonine</a:t>
              </a:r>
              <a:r>
                <a:rPr lang="en-US" sz="2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636 (pT636-Hsp70)</a:t>
              </a:r>
            </a:p>
          </p:txBody>
        </p: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4B02CC12-6063-E362-1A2C-57EE10E0300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8626" y="2055486"/>
              <a:ext cx="4859283" cy="2853558"/>
              <a:chOff x="654430" y="1607286"/>
              <a:chExt cx="5705646" cy="3350575"/>
            </a:xfrm>
          </p:grpSpPr>
          <p:pic>
            <p:nvPicPr>
              <p:cNvPr id="7" name="Picture 6" descr="A close-up of a scan&#10;&#10;Description automatically generated">
                <a:extLst>
                  <a:ext uri="{FF2B5EF4-FFF2-40B4-BE49-F238E27FC236}">
                    <a16:creationId xmlns:a16="http://schemas.microsoft.com/office/drawing/2014/main" id="{4CAC0A38-1039-B170-16C3-C2A9B1F38D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24" t="7228" r="45562" b="22779"/>
              <a:stretch/>
            </p:blipFill>
            <p:spPr>
              <a:xfrm>
                <a:off x="1033329" y="2434997"/>
                <a:ext cx="3920857" cy="2522864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D0037CF-7470-C30B-58A8-B6AB2F785B77}"/>
                  </a:ext>
                </a:extLst>
              </p:cNvPr>
              <p:cNvSpPr txBox="1"/>
              <p:nvPr/>
            </p:nvSpPr>
            <p:spPr>
              <a:xfrm rot="16200000">
                <a:off x="3177947" y="2060811"/>
                <a:ext cx="429143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37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33B44B4-4D6E-2AEA-A392-73B9CAD3A39E}"/>
                  </a:ext>
                </a:extLst>
              </p:cNvPr>
              <p:cNvSpPr txBox="1"/>
              <p:nvPr/>
            </p:nvSpPr>
            <p:spPr>
              <a:xfrm rot="16200000">
                <a:off x="3521486" y="2008450"/>
                <a:ext cx="540193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229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4EEF38B-1DBD-AD46-1153-062A79683E9D}"/>
                  </a:ext>
                </a:extLst>
              </p:cNvPr>
              <p:cNvSpPr txBox="1"/>
              <p:nvPr/>
            </p:nvSpPr>
            <p:spPr>
              <a:xfrm rot="16200000">
                <a:off x="3877141" y="1891312"/>
                <a:ext cx="784881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LC-GFP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4CF423A-CED3-7C9C-1765-3C17D2D96EA8}"/>
                  </a:ext>
                </a:extLst>
              </p:cNvPr>
              <p:cNvSpPr txBox="1"/>
              <p:nvPr/>
            </p:nvSpPr>
            <p:spPr>
              <a:xfrm rot="16200000">
                <a:off x="4534715" y="2056536"/>
                <a:ext cx="442319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i3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51B9918-A608-C991-0CA8-1C6237937C22}"/>
                  </a:ext>
                </a:extLst>
              </p:cNvPr>
              <p:cNvSpPr txBox="1"/>
              <p:nvPr/>
            </p:nvSpPr>
            <p:spPr>
              <a:xfrm rot="16200000">
                <a:off x="1804400" y="2013790"/>
                <a:ext cx="528900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2058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C4117EA-BA99-E883-47E0-2F07A26539D9}"/>
                  </a:ext>
                </a:extLst>
              </p:cNvPr>
              <p:cNvSpPr txBox="1"/>
              <p:nvPr/>
            </p:nvSpPr>
            <p:spPr>
              <a:xfrm rot="16200000">
                <a:off x="2204527" y="2013790"/>
                <a:ext cx="528900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1299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FDE05A5-A2EF-22E8-E3D1-333145942B4F}"/>
                  </a:ext>
                </a:extLst>
              </p:cNvPr>
              <p:cNvSpPr txBox="1"/>
              <p:nvPr/>
            </p:nvSpPr>
            <p:spPr>
              <a:xfrm rot="16200000">
                <a:off x="2638100" y="1960353"/>
                <a:ext cx="639950" cy="216830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t" anchorCtr="0">
                <a:spAutoFit/>
              </a:bodyPr>
              <a:lstStyle/>
              <a:p>
                <a:pPr algn="just" defTabSz="1219139">
                  <a:defRPr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sPC-1</a:t>
                </a:r>
              </a:p>
            </p:txBody>
          </p:sp>
          <p:sp>
            <p:nvSpPr>
              <p:cNvPr id="16" name="Isosceles Triangle 15">
                <a:extLst>
                  <a:ext uri="{FF2B5EF4-FFF2-40B4-BE49-F238E27FC236}">
                    <a16:creationId xmlns:a16="http://schemas.microsoft.com/office/drawing/2014/main" id="{D9E4F379-4EA2-E598-840E-9F0AAAE268B5}"/>
                  </a:ext>
                </a:extLst>
              </p:cNvPr>
              <p:cNvSpPr/>
              <p:nvPr/>
            </p:nvSpPr>
            <p:spPr>
              <a:xfrm rot="16373579">
                <a:off x="5047680" y="3818456"/>
                <a:ext cx="130686" cy="178516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AF2EAC3-5E06-9F8A-588B-BEE208A12B89}"/>
                  </a:ext>
                </a:extLst>
              </p:cNvPr>
              <p:cNvSpPr txBox="1"/>
              <p:nvPr/>
            </p:nvSpPr>
            <p:spPr>
              <a:xfrm>
                <a:off x="5168081" y="3764176"/>
                <a:ext cx="1191995" cy="3252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0 </a:t>
                </a:r>
                <a:r>
                  <a:rPr lang="en-US" sz="1200" b="1" dirty="0" err="1"/>
                  <a:t>kDa</a:t>
                </a:r>
                <a:endParaRPr lang="en-US" sz="1200" b="1" dirty="0"/>
              </a:p>
            </p:txBody>
          </p: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9F77EFFA-99EE-80DE-A660-8DEA97C7FE86}"/>
                  </a:ext>
                </a:extLst>
              </p:cNvPr>
              <p:cNvGrpSpPr/>
              <p:nvPr/>
            </p:nvGrpSpPr>
            <p:grpSpPr>
              <a:xfrm>
                <a:off x="654430" y="2434997"/>
                <a:ext cx="515846" cy="2478955"/>
                <a:chOff x="495070" y="1819560"/>
                <a:chExt cx="515846" cy="2478955"/>
              </a:xfrm>
            </p:grpSpPr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3EF047CC-9D40-8DDE-AC7A-6A9133A026CC}"/>
                    </a:ext>
                  </a:extLst>
                </p:cNvPr>
                <p:cNvSpPr txBox="1"/>
                <p:nvPr/>
              </p:nvSpPr>
              <p:spPr>
                <a:xfrm>
                  <a:off x="497558" y="1819560"/>
                  <a:ext cx="504808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250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4CAF46C-B752-162C-550F-EFDA602AB17E}"/>
                    </a:ext>
                  </a:extLst>
                </p:cNvPr>
                <p:cNvSpPr txBox="1"/>
                <p:nvPr/>
              </p:nvSpPr>
              <p:spPr>
                <a:xfrm>
                  <a:off x="506108" y="2241476"/>
                  <a:ext cx="504808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150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A1796FA8-BED8-AB21-CE6B-04E6F7E80CB3}"/>
                    </a:ext>
                  </a:extLst>
                </p:cNvPr>
                <p:cNvSpPr txBox="1"/>
                <p:nvPr/>
              </p:nvSpPr>
              <p:spPr>
                <a:xfrm>
                  <a:off x="495070" y="2708723"/>
                  <a:ext cx="504808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100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87AE07E7-DE04-AA63-0497-1DC3EEB17A47}"/>
                    </a:ext>
                  </a:extLst>
                </p:cNvPr>
                <p:cNvSpPr txBox="1"/>
                <p:nvPr/>
              </p:nvSpPr>
              <p:spPr>
                <a:xfrm>
                  <a:off x="537876" y="3037879"/>
                  <a:ext cx="408814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75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C092F634-472E-FDD8-4F6B-70B17AF13E1C}"/>
                    </a:ext>
                  </a:extLst>
                </p:cNvPr>
                <p:cNvSpPr txBox="1"/>
                <p:nvPr/>
              </p:nvSpPr>
              <p:spPr>
                <a:xfrm>
                  <a:off x="545505" y="3574824"/>
                  <a:ext cx="408814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50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2E6322DE-DCE8-509B-8EF0-2052FD0EA9A5}"/>
                    </a:ext>
                  </a:extLst>
                </p:cNvPr>
                <p:cNvSpPr txBox="1"/>
                <p:nvPr/>
              </p:nvSpPr>
              <p:spPr>
                <a:xfrm>
                  <a:off x="553134" y="3973270"/>
                  <a:ext cx="408814" cy="3252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37</a:t>
                  </a:r>
                </a:p>
              </p:txBody>
            </p:sp>
          </p:grpSp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6FCBC948-F540-9516-0596-4A7E3C8C84EF}"/>
                  </a:ext>
                </a:extLst>
              </p:cNvPr>
              <p:cNvSpPr/>
              <p:nvPr/>
            </p:nvSpPr>
            <p:spPr>
              <a:xfrm>
                <a:off x="1847165" y="3638285"/>
                <a:ext cx="3107021" cy="551976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/>
              </a:p>
            </p:txBody>
          </p: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590334E-A47A-D087-8EE6-132F5E438E2F}"/>
                </a:ext>
              </a:extLst>
            </p:cNvPr>
            <p:cNvGrpSpPr/>
            <p:nvPr/>
          </p:nvGrpSpPr>
          <p:grpSpPr>
            <a:xfrm>
              <a:off x="4628247" y="882662"/>
              <a:ext cx="5051338" cy="4047548"/>
              <a:chOff x="6417762" y="828308"/>
              <a:chExt cx="5360994" cy="4118391"/>
            </a:xfrm>
          </p:grpSpPr>
          <p:pic>
            <p:nvPicPr>
              <p:cNvPr id="79" name="Picture 78" descr="A close-up of a scan of a dna&#10;&#10;Description automatically generated">
                <a:extLst>
                  <a:ext uri="{FF2B5EF4-FFF2-40B4-BE49-F238E27FC236}">
                    <a16:creationId xmlns:a16="http://schemas.microsoft.com/office/drawing/2014/main" id="{2AB37C99-64DA-D58C-F6B4-324C788E35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0" t="6827" r="42629" b="9397"/>
              <a:stretch/>
            </p:blipFill>
            <p:spPr>
              <a:xfrm>
                <a:off x="6939651" y="2733756"/>
                <a:ext cx="3499467" cy="2212943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D704334-0317-5BBA-9E94-D1D7A3C2ACD4}"/>
                  </a:ext>
                </a:extLst>
              </p:cNvPr>
              <p:cNvSpPr txBox="1"/>
              <p:nvPr/>
            </p:nvSpPr>
            <p:spPr>
              <a:xfrm>
                <a:off x="7085435" y="828308"/>
                <a:ext cx="3161341" cy="62632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>
                  <a:defRPr/>
                </a:pPr>
                <a:r>
                  <a:rPr lang="en-US" sz="2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sp70</a:t>
                </a:r>
                <a:br>
                  <a:rPr lang="en-US" sz="2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endParaRPr lang="en-US" sz="2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5" name="Group 74">
                <a:extLst>
                  <a:ext uri="{FF2B5EF4-FFF2-40B4-BE49-F238E27FC236}">
                    <a16:creationId xmlns:a16="http://schemas.microsoft.com/office/drawing/2014/main" id="{67693367-D96C-FDFF-CE55-56DC49D80E4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417762" y="2018603"/>
                <a:ext cx="5360994" cy="2919248"/>
                <a:chOff x="6858000" y="1618700"/>
                <a:chExt cx="6006522" cy="3270761"/>
              </a:xfrm>
            </p:grpSpPr>
            <p:grpSp>
              <p:nvGrpSpPr>
                <p:cNvPr id="52" name="Group 51">
                  <a:extLst>
                    <a:ext uri="{FF2B5EF4-FFF2-40B4-BE49-F238E27FC236}">
                      <a16:creationId xmlns:a16="http://schemas.microsoft.com/office/drawing/2014/main" id="{27F0D03F-CDD7-94BC-78B6-B380296BCFA0}"/>
                    </a:ext>
                  </a:extLst>
                </p:cNvPr>
                <p:cNvGrpSpPr/>
                <p:nvPr/>
              </p:nvGrpSpPr>
              <p:grpSpPr>
                <a:xfrm>
                  <a:off x="6858000" y="1618700"/>
                  <a:ext cx="6006522" cy="3270761"/>
                  <a:chOff x="6932154" y="1700394"/>
                  <a:chExt cx="6006522" cy="3270761"/>
                </a:xfrm>
              </p:grpSpPr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CACE5178-A2D7-523D-F738-9A37A6B51108}"/>
                      </a:ext>
                    </a:extLst>
                  </p:cNvPr>
                  <p:cNvGrpSpPr/>
                  <p:nvPr/>
                </p:nvGrpSpPr>
                <p:grpSpPr>
                  <a:xfrm>
                    <a:off x="6932154" y="2501660"/>
                    <a:ext cx="522261" cy="2469495"/>
                    <a:chOff x="495070" y="1819560"/>
                    <a:chExt cx="522261" cy="2469495"/>
                  </a:xfrm>
                </p:grpSpPr>
                <p:sp>
                  <p:nvSpPr>
                    <p:cNvPr id="35" name="TextBox 34">
                      <a:extLst>
                        <a:ext uri="{FF2B5EF4-FFF2-40B4-BE49-F238E27FC236}">
                          <a16:creationId xmlns:a16="http://schemas.microsoft.com/office/drawing/2014/main" id="{1DAF0B83-362B-BEB7-E52C-9322FD8A7D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558" y="1819560"/>
                      <a:ext cx="511223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250</a:t>
                      </a:r>
                    </a:p>
                  </p:txBody>
                </p:sp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F3F395E5-BEF1-20E6-BDCB-0FD05400CF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6108" y="2241476"/>
                      <a:ext cx="511223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50</a:t>
                      </a:r>
                    </a:p>
                  </p:txBody>
                </p: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4E8E83F6-057C-A9B6-79DA-9D988A93E4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070" y="2708722"/>
                      <a:ext cx="511223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00</a:t>
                      </a:r>
                    </a:p>
                  </p:txBody>
                </p: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BD6D7E67-0E8D-6E2B-9C1E-CF9FD686604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876" y="3037879"/>
                      <a:ext cx="414009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75</a:t>
                      </a: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4E377525-EF1E-3A31-D919-34A5CFA1F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5505" y="3574824"/>
                      <a:ext cx="414009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50</a:t>
                      </a: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1586F8ED-46E0-62B5-9FED-0C1CD40650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3133" y="3973270"/>
                      <a:ext cx="414009" cy="3157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37</a:t>
                      </a:r>
                    </a:p>
                  </p:txBody>
                </p:sp>
              </p:grp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4846B7EE-6FD5-AC3D-EF75-035F115975B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9579013" y="2141127"/>
                    <a:ext cx="416661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373</a:t>
                    </a: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20530A9E-D78C-8EBA-D4BC-05F9515D8B5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9924168" y="2088766"/>
                    <a:ext cx="524481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N229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446D9E8C-B470-737F-748B-9B9002D7281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0283381" y="1971627"/>
                    <a:ext cx="762051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LC-GFP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B9C88AF3-0999-2E49-4B58-E0A8B8D729E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0935973" y="2136851"/>
                    <a:ext cx="429453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i36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4DF8A6C5-8134-1D78-72BF-79FDB85803D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8206918" y="2094106"/>
                    <a:ext cx="513516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2058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77D8BC38-68D3-8C9F-7B48-108D4AF82B7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8607045" y="2094106"/>
                    <a:ext cx="513516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1299</a:t>
                    </a:r>
                  </a:p>
                </p:txBody>
              </p:sp>
              <p:sp>
                <p:nvSpPr>
                  <p:cNvPr id="49" name="TextBox 48">
                    <a:extLst>
                      <a:ext uri="{FF2B5EF4-FFF2-40B4-BE49-F238E27FC236}">
                        <a16:creationId xmlns:a16="http://schemas.microsoft.com/office/drawing/2014/main" id="{76A1BEC1-5480-EEE0-A4B0-DB04616266A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9042232" y="2040670"/>
                    <a:ext cx="621336" cy="219585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sPC-1</a:t>
                    </a:r>
                  </a:p>
                </p:txBody>
              </p:sp>
              <p:sp>
                <p:nvSpPr>
                  <p:cNvPr id="50" name="Isosceles Triangle 49">
                    <a:extLst>
                      <a:ext uri="{FF2B5EF4-FFF2-40B4-BE49-F238E27FC236}">
                        <a16:creationId xmlns:a16="http://schemas.microsoft.com/office/drawing/2014/main" id="{A61B0009-140F-3800-AF3B-300864AE0D8A}"/>
                      </a:ext>
                    </a:extLst>
                  </p:cNvPr>
                  <p:cNvSpPr/>
                  <p:nvPr/>
                </p:nvSpPr>
                <p:spPr>
                  <a:xfrm rot="16373579">
                    <a:off x="11626280" y="3882163"/>
                    <a:ext cx="130686" cy="178516"/>
                  </a:xfrm>
                  <a:prstGeom prst="triangle">
                    <a:avLst/>
                  </a:prstGeom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 b="1"/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7B84938E-117E-2795-79B4-D57365289A3A}"/>
                      </a:ext>
                    </a:extLst>
                  </p:cNvPr>
                  <p:cNvSpPr txBox="1"/>
                  <p:nvPr/>
                </p:nvSpPr>
                <p:spPr>
                  <a:xfrm>
                    <a:off x="11746681" y="3827883"/>
                    <a:ext cx="1191995" cy="315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70 </a:t>
                    </a:r>
                    <a:r>
                      <a:rPr lang="en-US" sz="1200" b="1" dirty="0" err="1"/>
                      <a:t>kDa</a:t>
                    </a:r>
                    <a:endParaRPr lang="en-US" sz="1200" b="1" dirty="0"/>
                  </a:p>
                </p:txBody>
              </p:sp>
            </p:grpSp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C517C35A-2FC4-4244-18D0-293CD35925D9}"/>
                    </a:ext>
                  </a:extLst>
                </p:cNvPr>
                <p:cNvSpPr/>
                <p:nvPr/>
              </p:nvSpPr>
              <p:spPr>
                <a:xfrm>
                  <a:off x="8223933" y="3638286"/>
                  <a:ext cx="3072889" cy="499007"/>
                </a:xfrm>
                <a:prstGeom prst="rect">
                  <a:avLst/>
                </a:pr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b="1"/>
                </a:p>
              </p:txBody>
            </p:sp>
          </p:grp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AEFF3A1-C132-5E2F-5C8F-DFC0281B75B8}"/>
                </a:ext>
              </a:extLst>
            </p:cNvPr>
            <p:cNvGrpSpPr/>
            <p:nvPr/>
          </p:nvGrpSpPr>
          <p:grpSpPr>
            <a:xfrm>
              <a:off x="9098812" y="937888"/>
              <a:ext cx="4793729" cy="3845982"/>
              <a:chOff x="549710" y="5728142"/>
              <a:chExt cx="5256816" cy="4035536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F6F4F62-9FBA-9D31-BDC9-420FBDFDFC1A}"/>
                  </a:ext>
                </a:extLst>
              </p:cNvPr>
              <p:cNvSpPr txBox="1"/>
              <p:nvPr/>
            </p:nvSpPr>
            <p:spPr>
              <a:xfrm>
                <a:off x="549710" y="5728142"/>
                <a:ext cx="3161341" cy="32294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>
                  <a:defRPr/>
                </a:pPr>
                <a:r>
                  <a:rPr lang="en-US" sz="2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63151422-91E9-E11E-0BCC-3DEC03B4395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61687" y="6781476"/>
                <a:ext cx="5044839" cy="2982202"/>
                <a:chOff x="722826" y="7095064"/>
                <a:chExt cx="5723883" cy="3383612"/>
              </a:xfrm>
            </p:grpSpPr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1B1C48DA-AC63-0B4A-20AB-1B94348BC9B2}"/>
                    </a:ext>
                  </a:extLst>
                </p:cNvPr>
                <p:cNvGrpSpPr/>
                <p:nvPr/>
              </p:nvGrpSpPr>
              <p:grpSpPr>
                <a:xfrm>
                  <a:off x="722826" y="7095064"/>
                  <a:ext cx="5723883" cy="3383612"/>
                  <a:chOff x="627734" y="5052555"/>
                  <a:chExt cx="5723883" cy="3383612"/>
                </a:xfrm>
              </p:grpSpPr>
              <p:pic>
                <p:nvPicPr>
                  <p:cNvPr id="23" name="Picture 22" descr="031920 act lysate mertip tr2_4+031920 act lysate mertip tr2_8.tif">
                    <a:extLst>
                      <a:ext uri="{FF2B5EF4-FFF2-40B4-BE49-F238E27FC236}">
                        <a16:creationId xmlns:a16="http://schemas.microsoft.com/office/drawing/2014/main" id="{5605C9E7-627E-C784-FB06-98E7F0D97C1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0070" t="40188" r="48422" b="35080"/>
                  <a:stretch/>
                </p:blipFill>
                <p:spPr>
                  <a:xfrm>
                    <a:off x="1002439" y="5945569"/>
                    <a:ext cx="3982636" cy="2490598"/>
                  </a:xfrm>
                  <a:prstGeom prst="rect">
                    <a:avLst/>
                  </a:prstGeom>
                </p:spPr>
              </p:pic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D9EDC7C4-05EE-2F0D-AE60-94718D3CEF6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148262" y="5505076"/>
                    <a:ext cx="435118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373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2DC2925A-D3F4-7AF1-D75D-E72FC91FEAF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491029" y="5452716"/>
                    <a:ext cx="547714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N229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FBDD96F5-DD25-B5E4-D19A-CACEFEB0B59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844981" y="5335577"/>
                    <a:ext cx="795808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LC-GFP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85C793FA-A39F-1330-4667-F8502A3D8A9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504941" y="5500801"/>
                    <a:ext cx="448477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i36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97B4D721-EC3E-2C57-1823-E3A1FB5D5A4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74022" y="5458056"/>
                    <a:ext cx="536264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2058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7629DB78-81AF-33D6-D660-5AB45DBC835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74149" y="5458056"/>
                    <a:ext cx="536264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1299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AE3558F7-B4E1-0F6A-8C2C-8E09B1FC1B1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606950" y="5404619"/>
                    <a:ext cx="648860" cy="22976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t" anchorCtr="0">
                    <a:spAutoFit/>
                  </a:bodyPr>
                  <a:lstStyle/>
                  <a:p>
                    <a:pPr algn="just" defTabSz="1219139">
                      <a:defRPr/>
                    </a:pPr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sPC-1</a:t>
                    </a:r>
                  </a:p>
                </p:txBody>
              </p:sp>
              <p:sp>
                <p:nvSpPr>
                  <p:cNvPr id="60" name="Isosceles Triangle 59">
                    <a:extLst>
                      <a:ext uri="{FF2B5EF4-FFF2-40B4-BE49-F238E27FC236}">
                        <a16:creationId xmlns:a16="http://schemas.microsoft.com/office/drawing/2014/main" id="{D046DDE7-4101-15E1-0377-C6821AD11EDC}"/>
                      </a:ext>
                    </a:extLst>
                  </p:cNvPr>
                  <p:cNvSpPr/>
                  <p:nvPr/>
                </p:nvSpPr>
                <p:spPr>
                  <a:xfrm rot="16373579">
                    <a:off x="5039221" y="7920657"/>
                    <a:ext cx="130686" cy="178516"/>
                  </a:xfrm>
                  <a:prstGeom prst="triangle">
                    <a:avLst/>
                  </a:prstGeom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 b="1"/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B165A5DC-8425-A129-8BD8-01188DC52713}"/>
                      </a:ext>
                    </a:extLst>
                  </p:cNvPr>
                  <p:cNvSpPr txBox="1"/>
                  <p:nvPr/>
                </p:nvSpPr>
                <p:spPr>
                  <a:xfrm>
                    <a:off x="5159621" y="7866377"/>
                    <a:ext cx="1191996" cy="3297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70 </a:t>
                    </a:r>
                    <a:r>
                      <a:rPr lang="en-US" sz="1200" b="1" dirty="0" err="1"/>
                      <a:t>kDa</a:t>
                    </a:r>
                    <a:endParaRPr lang="en-US" sz="1200" b="1" dirty="0"/>
                  </a:p>
                </p:txBody>
              </p:sp>
              <p:grpSp>
                <p:nvGrpSpPr>
                  <p:cNvPr id="62" name="Group 61">
                    <a:extLst>
                      <a:ext uri="{FF2B5EF4-FFF2-40B4-BE49-F238E27FC236}">
                        <a16:creationId xmlns:a16="http://schemas.microsoft.com/office/drawing/2014/main" id="{E8D2D764-1653-559B-95AB-DAEC45AC2D16}"/>
                      </a:ext>
                    </a:extLst>
                  </p:cNvPr>
                  <p:cNvGrpSpPr/>
                  <p:nvPr/>
                </p:nvGrpSpPr>
                <p:grpSpPr>
                  <a:xfrm>
                    <a:off x="627734" y="5885729"/>
                    <a:ext cx="545956" cy="2483484"/>
                    <a:chOff x="495070" y="1819560"/>
                    <a:chExt cx="545956" cy="2483484"/>
                  </a:xfrm>
                </p:grpSpPr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9E2D0B3C-74C0-245E-8BB6-1A335BFAC9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558" y="1819560"/>
                      <a:ext cx="534917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250</a:t>
                      </a:r>
                    </a:p>
                  </p:txBody>
                </p:sp>
                <p:sp>
                  <p:nvSpPr>
                    <p:cNvPr id="64" name="TextBox 63">
                      <a:extLst>
                        <a:ext uri="{FF2B5EF4-FFF2-40B4-BE49-F238E27FC236}">
                          <a16:creationId xmlns:a16="http://schemas.microsoft.com/office/drawing/2014/main" id="{C0E92ED1-C514-2A1E-6D0D-B5023BBB22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6109" y="2241476"/>
                      <a:ext cx="534917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50</a:t>
                      </a:r>
                    </a:p>
                  </p:txBody>
                </p:sp>
                <p:sp>
                  <p:nvSpPr>
                    <p:cNvPr id="65" name="TextBox 64">
                      <a:extLst>
                        <a:ext uri="{FF2B5EF4-FFF2-40B4-BE49-F238E27FC236}">
                          <a16:creationId xmlns:a16="http://schemas.microsoft.com/office/drawing/2014/main" id="{839A094D-99A2-7708-F3AA-5354D308627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070" y="2708722"/>
                      <a:ext cx="534917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00</a:t>
                      </a:r>
                    </a:p>
                  </p:txBody>
                </p:sp>
                <p:sp>
                  <p:nvSpPr>
                    <p:cNvPr id="66" name="TextBox 65">
                      <a:extLst>
                        <a:ext uri="{FF2B5EF4-FFF2-40B4-BE49-F238E27FC236}">
                          <a16:creationId xmlns:a16="http://schemas.microsoft.com/office/drawing/2014/main" id="{EAEC454A-CA81-E409-698A-E88A6AC21FD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876" y="3037879"/>
                      <a:ext cx="433198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75</a:t>
                      </a:r>
                    </a:p>
                  </p:txBody>
                </p:sp>
                <p:sp>
                  <p:nvSpPr>
                    <p:cNvPr id="67" name="TextBox 66">
                      <a:extLst>
                        <a:ext uri="{FF2B5EF4-FFF2-40B4-BE49-F238E27FC236}">
                          <a16:creationId xmlns:a16="http://schemas.microsoft.com/office/drawing/2014/main" id="{1BFD408B-697F-D7CE-AC83-99B3037C61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5505" y="3574825"/>
                      <a:ext cx="433198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50</a:t>
                      </a:r>
                    </a:p>
                  </p:txBody>
                </p:sp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76EDC82B-98E3-07DD-AE4D-5F665A79E8F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3133" y="3973270"/>
                      <a:ext cx="433198" cy="3297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37</a:t>
                      </a:r>
                    </a:p>
                  </p:txBody>
                </p:sp>
              </p:grpSp>
            </p:grpSp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30A14726-657F-FC83-67BF-2DEA26F6BFE1}"/>
                    </a:ext>
                  </a:extLst>
                </p:cNvPr>
                <p:cNvSpPr/>
                <p:nvPr/>
              </p:nvSpPr>
              <p:spPr>
                <a:xfrm>
                  <a:off x="1904838" y="9841210"/>
                  <a:ext cx="3111662" cy="475237"/>
                </a:xfrm>
                <a:prstGeom prst="rect">
                  <a:avLst/>
                </a:pr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b="1"/>
                </a:p>
              </p:txBody>
            </p:sp>
          </p:grp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8395BC0C-6B2E-1A1B-086D-67120FA59FA9}"/>
              </a:ext>
            </a:extLst>
          </p:cNvPr>
          <p:cNvSpPr txBox="1"/>
          <p:nvPr/>
        </p:nvSpPr>
        <p:spPr>
          <a:xfrm>
            <a:off x="482205" y="5696900"/>
            <a:ext cx="18213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, right pane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C5B7EC1-32E8-C1BB-7EBC-35B83F7215FA}"/>
              </a:ext>
            </a:extLst>
          </p:cNvPr>
          <p:cNvSpPr txBox="1"/>
          <p:nvPr/>
        </p:nvSpPr>
        <p:spPr>
          <a:xfrm>
            <a:off x="753344" y="6167669"/>
            <a:ext cx="413251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 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tyrosine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an-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/>
            <a:endParaRPr 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593D3D8-293B-CD06-40A2-9646A4BDAE96}"/>
              </a:ext>
            </a:extLst>
          </p:cNvPr>
          <p:cNvSpPr txBox="1"/>
          <p:nvPr/>
        </p:nvSpPr>
        <p:spPr>
          <a:xfrm>
            <a:off x="5284251" y="6167667"/>
            <a:ext cx="1633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 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7499FCE-97EC-D680-4605-6A258ACA6ED1}"/>
              </a:ext>
            </a:extLst>
          </p:cNvPr>
          <p:cNvSpPr txBox="1"/>
          <p:nvPr/>
        </p:nvSpPr>
        <p:spPr>
          <a:xfrm>
            <a:off x="9596808" y="6167667"/>
            <a:ext cx="11128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6E02D398-B9C0-9623-AFB3-6B882AA76DC9}"/>
              </a:ext>
            </a:extLst>
          </p:cNvPr>
          <p:cNvGrpSpPr/>
          <p:nvPr/>
        </p:nvGrpSpPr>
        <p:grpSpPr>
          <a:xfrm>
            <a:off x="491138" y="7147796"/>
            <a:ext cx="13733275" cy="3422983"/>
            <a:chOff x="374508" y="6463517"/>
            <a:chExt cx="13733275" cy="3422983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6B72352-40DB-2AF4-7B5E-F1157C2682BC}"/>
                </a:ext>
              </a:extLst>
            </p:cNvPr>
            <p:cNvGrpSpPr/>
            <p:nvPr/>
          </p:nvGrpSpPr>
          <p:grpSpPr>
            <a:xfrm>
              <a:off x="744316" y="7345174"/>
              <a:ext cx="3172795" cy="2329664"/>
              <a:chOff x="525780" y="2828410"/>
              <a:chExt cx="2445173" cy="1489287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879F8501-4DAF-B077-A14D-B701F38BB5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65" t="21104" r="22305" b="43328"/>
              <a:stretch/>
            </p:blipFill>
            <p:spPr>
              <a:xfrm>
                <a:off x="525780" y="2828410"/>
                <a:ext cx="2445173" cy="1489287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2251F9DD-A928-23D7-3189-0238C89A2057}"/>
                  </a:ext>
                </a:extLst>
              </p:cNvPr>
              <p:cNvSpPr/>
              <p:nvPr/>
            </p:nvSpPr>
            <p:spPr>
              <a:xfrm>
                <a:off x="792789" y="3288211"/>
                <a:ext cx="1498501" cy="22632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/>
              </a:p>
            </p:txBody>
          </p:sp>
        </p:grpSp>
        <p:sp>
          <p:nvSpPr>
            <p:cNvPr id="22" name="Isosceles Triangle 21">
              <a:extLst>
                <a:ext uri="{FF2B5EF4-FFF2-40B4-BE49-F238E27FC236}">
                  <a16:creationId xmlns:a16="http://schemas.microsoft.com/office/drawing/2014/main" id="{495555B6-3B61-4FD3-43AD-3B757CD14BA2}"/>
                </a:ext>
              </a:extLst>
            </p:cNvPr>
            <p:cNvSpPr/>
            <p:nvPr/>
          </p:nvSpPr>
          <p:spPr>
            <a:xfrm rot="16373579">
              <a:off x="4009646" y="8152191"/>
              <a:ext cx="130686" cy="178516"/>
            </a:xfrm>
            <a:prstGeom prst="triangl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EB2296A-FF75-AAB3-D808-E5345251D80D}"/>
                </a:ext>
              </a:extLst>
            </p:cNvPr>
            <p:cNvSpPr txBox="1"/>
            <p:nvPr/>
          </p:nvSpPr>
          <p:spPr>
            <a:xfrm>
              <a:off x="4130047" y="8097911"/>
              <a:ext cx="119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7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8AB226E-5389-4506-1EB2-53503606976A}"/>
                </a:ext>
              </a:extLst>
            </p:cNvPr>
            <p:cNvSpPr txBox="1"/>
            <p:nvPr/>
          </p:nvSpPr>
          <p:spPr>
            <a:xfrm rot="16200000">
              <a:off x="986097" y="6924287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FC2B4AA-E182-B39E-5DF8-2123FD9A94BE}"/>
                </a:ext>
              </a:extLst>
            </p:cNvPr>
            <p:cNvSpPr txBox="1"/>
            <p:nvPr/>
          </p:nvSpPr>
          <p:spPr>
            <a:xfrm rot="16200000">
              <a:off x="1182793" y="6924287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05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262F1CC-60EA-D806-0823-63E2DA4C3515}"/>
                </a:ext>
              </a:extLst>
            </p:cNvPr>
            <p:cNvSpPr txBox="1"/>
            <p:nvPr/>
          </p:nvSpPr>
          <p:spPr>
            <a:xfrm rot="16200000">
              <a:off x="1332199" y="6869121"/>
              <a:ext cx="545021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PC-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9430D3D-1FC6-A03C-5D73-B70437BF61F3}"/>
                </a:ext>
              </a:extLst>
            </p:cNvPr>
            <p:cNvSpPr txBox="1"/>
            <p:nvPr/>
          </p:nvSpPr>
          <p:spPr>
            <a:xfrm rot="16200000">
              <a:off x="2492733" y="6969423"/>
              <a:ext cx="37670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li36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60BD46D-C632-861E-AF7F-C18DFDD7F678}"/>
                </a:ext>
              </a:extLst>
            </p:cNvPr>
            <p:cNvSpPr txBox="1"/>
            <p:nvPr/>
          </p:nvSpPr>
          <p:spPr>
            <a:xfrm rot="16200000">
              <a:off x="2556371" y="6798910"/>
              <a:ext cx="668453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LC-GFP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7B33650-4A19-8EA9-3625-D3A897BDD4DF}"/>
                </a:ext>
              </a:extLst>
            </p:cNvPr>
            <p:cNvSpPr txBox="1"/>
            <p:nvPr/>
          </p:nvSpPr>
          <p:spPr>
            <a:xfrm rot="16200000">
              <a:off x="1820424" y="6919272"/>
              <a:ext cx="460062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N229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075D694A-9372-00D1-843D-D9D0CF81560A}"/>
                </a:ext>
              </a:extLst>
            </p:cNvPr>
            <p:cNvSpPr txBox="1"/>
            <p:nvPr/>
          </p:nvSpPr>
          <p:spPr>
            <a:xfrm rot="16200000">
              <a:off x="2106187" y="6974438"/>
              <a:ext cx="365485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373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4EEDB22-8AD6-BC60-6459-901C3B5C58C4}"/>
                </a:ext>
              </a:extLst>
            </p:cNvPr>
            <p:cNvSpPr txBox="1"/>
            <p:nvPr/>
          </p:nvSpPr>
          <p:spPr>
            <a:xfrm rot="16200000">
              <a:off x="1424054" y="6759111"/>
              <a:ext cx="775853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iaPaCa-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84795488-3D41-8DC0-01E5-5E34532DA04F}"/>
                </a:ext>
              </a:extLst>
            </p:cNvPr>
            <p:cNvSpPr txBox="1"/>
            <p:nvPr/>
          </p:nvSpPr>
          <p:spPr>
            <a:xfrm rot="16200000">
              <a:off x="2313654" y="6974438"/>
              <a:ext cx="365485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 anchorCtr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343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FA7A93FF-BC6D-9732-536F-735288642F48}"/>
                </a:ext>
              </a:extLst>
            </p:cNvPr>
            <p:cNvGrpSpPr/>
            <p:nvPr/>
          </p:nvGrpSpPr>
          <p:grpSpPr>
            <a:xfrm>
              <a:off x="374508" y="7282420"/>
              <a:ext cx="434901" cy="2444671"/>
              <a:chOff x="492583" y="1819560"/>
              <a:chExt cx="434901" cy="2444671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CB05A895-83A9-88D1-9175-251657492FC8}"/>
                  </a:ext>
                </a:extLst>
              </p:cNvPr>
              <p:cNvSpPr txBox="1"/>
              <p:nvPr/>
            </p:nvSpPr>
            <p:spPr>
              <a:xfrm>
                <a:off x="497558" y="1819560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50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625FB6DC-0C78-C51F-3473-38DB6F220C51}"/>
                  </a:ext>
                </a:extLst>
              </p:cNvPr>
              <p:cNvSpPr txBox="1"/>
              <p:nvPr/>
            </p:nvSpPr>
            <p:spPr>
              <a:xfrm>
                <a:off x="497558" y="2104311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0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6444CF38-4808-9426-F783-7AB9F8BA3A1F}"/>
                  </a:ext>
                </a:extLst>
              </p:cNvPr>
              <p:cNvSpPr txBox="1"/>
              <p:nvPr/>
            </p:nvSpPr>
            <p:spPr>
              <a:xfrm>
                <a:off x="492583" y="2406023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0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5CC2D973-38D2-C68A-5515-E5D48FC45B54}"/>
                  </a:ext>
                </a:extLst>
              </p:cNvPr>
              <p:cNvSpPr txBox="1"/>
              <p:nvPr/>
            </p:nvSpPr>
            <p:spPr>
              <a:xfrm>
                <a:off x="512933" y="2630559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75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3381F6FC-4B9E-D144-4843-425CC1BA74ED}"/>
                  </a:ext>
                </a:extLst>
              </p:cNvPr>
              <p:cNvSpPr txBox="1"/>
              <p:nvPr/>
            </p:nvSpPr>
            <p:spPr>
              <a:xfrm>
                <a:off x="545568" y="3001650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50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4A07DF25-78F6-EF34-815D-E603C86121EA}"/>
                  </a:ext>
                </a:extLst>
              </p:cNvPr>
              <p:cNvSpPr txBox="1"/>
              <p:nvPr/>
            </p:nvSpPr>
            <p:spPr>
              <a:xfrm>
                <a:off x="545568" y="3359925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7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E35F4AA4-2A6E-C6F6-464A-506FEFF01D61}"/>
                  </a:ext>
                </a:extLst>
              </p:cNvPr>
              <p:cNvSpPr txBox="1"/>
              <p:nvPr/>
            </p:nvSpPr>
            <p:spPr>
              <a:xfrm>
                <a:off x="545568" y="3718201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5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41AB04C7-F092-54BB-17DE-9D7640E9F645}"/>
                  </a:ext>
                </a:extLst>
              </p:cNvPr>
              <p:cNvSpPr txBox="1"/>
              <p:nvPr/>
            </p:nvSpPr>
            <p:spPr>
              <a:xfrm>
                <a:off x="535602" y="3987232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0</a:t>
                </a:r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240D59E6-2DF0-EDDF-78AB-EC343C958EDE}"/>
                </a:ext>
              </a:extLst>
            </p:cNvPr>
            <p:cNvGrpSpPr/>
            <p:nvPr/>
          </p:nvGrpSpPr>
          <p:grpSpPr>
            <a:xfrm>
              <a:off x="4896373" y="6517999"/>
              <a:ext cx="4874215" cy="3277604"/>
              <a:chOff x="5124565" y="6301009"/>
              <a:chExt cx="3860463" cy="2067243"/>
            </a:xfrm>
          </p:grpSpPr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53625E2D-FC4E-4BC4-2ED8-F5C28922ACD0}"/>
                  </a:ext>
                </a:extLst>
              </p:cNvPr>
              <p:cNvSpPr txBox="1"/>
              <p:nvPr/>
            </p:nvSpPr>
            <p:spPr>
              <a:xfrm>
                <a:off x="8066395" y="7421074"/>
                <a:ext cx="918633" cy="1747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0 </a:t>
                </a:r>
                <a:r>
                  <a:rPr lang="en-US" sz="1200" b="1" dirty="0" err="1"/>
                  <a:t>kDa</a:t>
                </a:r>
                <a:endParaRPr lang="en-US" sz="1200" b="1" dirty="0"/>
              </a:p>
            </p:txBody>
          </p: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666C520F-F348-C08A-4DC2-480BB3E1FC2D}"/>
                  </a:ext>
                </a:extLst>
              </p:cNvPr>
              <p:cNvGrpSpPr/>
              <p:nvPr/>
            </p:nvGrpSpPr>
            <p:grpSpPr>
              <a:xfrm>
                <a:off x="5451829" y="6861522"/>
                <a:ext cx="2630824" cy="1489286"/>
                <a:chOff x="3351107" y="660943"/>
                <a:chExt cx="2630824" cy="1489286"/>
              </a:xfrm>
            </p:grpSpPr>
            <p:pic>
              <p:nvPicPr>
                <p:cNvPr id="105" name="Picture 104">
                  <a:extLst>
                    <a:ext uri="{FF2B5EF4-FFF2-40B4-BE49-F238E27FC236}">
                      <a16:creationId xmlns:a16="http://schemas.microsoft.com/office/drawing/2014/main" id="{292B003F-EE96-7BA1-2766-1401F5E3F8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925" t="21011" r="19304" b="44244"/>
                <a:stretch/>
              </p:blipFill>
              <p:spPr>
                <a:xfrm>
                  <a:off x="3351107" y="660943"/>
                  <a:ext cx="2440364" cy="1489286"/>
                </a:xfrm>
                <a:prstGeom prst="rect">
                  <a:avLst/>
                </a:prstGeom>
              </p:spPr>
            </p:pic>
            <p:sp>
              <p:nvSpPr>
                <p:cNvPr id="107" name="Rectangle 106">
                  <a:extLst>
                    <a:ext uri="{FF2B5EF4-FFF2-40B4-BE49-F238E27FC236}">
                      <a16:creationId xmlns:a16="http://schemas.microsoft.com/office/drawing/2014/main" id="{BC1DD62E-47A4-261C-7E28-05702F563159}"/>
                    </a:ext>
                  </a:extLst>
                </p:cNvPr>
                <p:cNvSpPr/>
                <p:nvPr/>
              </p:nvSpPr>
              <p:spPr>
                <a:xfrm>
                  <a:off x="3572933" y="1103457"/>
                  <a:ext cx="1574800" cy="331643"/>
                </a:xfrm>
                <a:prstGeom prst="rect">
                  <a:avLst/>
                </a:pr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just"/>
                  <a:endPara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Isosceles Triangle 115">
                  <a:extLst>
                    <a:ext uri="{FF2B5EF4-FFF2-40B4-BE49-F238E27FC236}">
                      <a16:creationId xmlns:a16="http://schemas.microsoft.com/office/drawing/2014/main" id="{67CBA94D-38A6-BB6F-35E1-C8714E43C5FA}"/>
                    </a:ext>
                  </a:extLst>
                </p:cNvPr>
                <p:cNvSpPr/>
                <p:nvPr/>
              </p:nvSpPr>
              <p:spPr>
                <a:xfrm rot="16373579">
                  <a:off x="5871371" y="1233091"/>
                  <a:ext cx="83544" cy="137577"/>
                </a:xfrm>
                <a:prstGeom prst="triangle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b="1"/>
                </a:p>
              </p:txBody>
            </p:sp>
          </p:grpSp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id="{B0096697-FA43-642B-B36F-D638BDEBD010}"/>
                  </a:ext>
                </a:extLst>
              </p:cNvPr>
              <p:cNvGrpSpPr/>
              <p:nvPr/>
            </p:nvGrpSpPr>
            <p:grpSpPr>
              <a:xfrm>
                <a:off x="5698595" y="6301009"/>
                <a:ext cx="1440426" cy="498129"/>
                <a:chOff x="3886326" y="100429"/>
                <a:chExt cx="1440426" cy="498129"/>
              </a:xfrm>
            </p:grpSpPr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2F2EB027-359F-7B84-13A8-FDDF2719077B}"/>
                    </a:ext>
                  </a:extLst>
                </p:cNvPr>
                <p:cNvSpPr txBox="1"/>
                <p:nvPr/>
              </p:nvSpPr>
              <p:spPr>
                <a:xfrm rot="16200000">
                  <a:off x="3817404" y="377778"/>
                  <a:ext cx="284103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299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29809780-542D-AF49-21BF-F9D91EEF83BB}"/>
                    </a:ext>
                  </a:extLst>
                </p:cNvPr>
                <p:cNvSpPr txBox="1"/>
                <p:nvPr/>
              </p:nvSpPr>
              <p:spPr>
                <a:xfrm rot="16200000">
                  <a:off x="3968991" y="377778"/>
                  <a:ext cx="284103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2058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483BF2B9-A0B1-0CD6-84B0-77BA9656E68F}"/>
                    </a:ext>
                  </a:extLst>
                </p:cNvPr>
                <p:cNvSpPr txBox="1"/>
                <p:nvPr/>
              </p:nvSpPr>
              <p:spPr>
                <a:xfrm rot="16200000">
                  <a:off x="4090753" y="342511"/>
                  <a:ext cx="343754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C-1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2267D0E5-1D03-CF68-0AC1-AFA97629FA02}"/>
                    </a:ext>
                  </a:extLst>
                </p:cNvPr>
                <p:cNvSpPr txBox="1"/>
                <p:nvPr/>
              </p:nvSpPr>
              <p:spPr>
                <a:xfrm rot="16200000">
                  <a:off x="4973361" y="406631"/>
                  <a:ext cx="237595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i36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E907EE61-A446-E20F-D063-55B24E993370}"/>
                    </a:ext>
                  </a:extLst>
                </p:cNvPr>
                <p:cNvSpPr txBox="1"/>
                <p:nvPr/>
              </p:nvSpPr>
              <p:spPr>
                <a:xfrm rot="16200000">
                  <a:off x="5042820" y="297628"/>
                  <a:ext cx="421605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LC-GFP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E938A04A-438F-FC7D-3315-6357AC6D79C3}"/>
                    </a:ext>
                  </a:extLst>
                </p:cNvPr>
                <p:cNvSpPr txBox="1"/>
                <p:nvPr/>
              </p:nvSpPr>
              <p:spPr>
                <a:xfrm rot="16200000">
                  <a:off x="4461066" y="374571"/>
                  <a:ext cx="290169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229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9A2CD47A-48D5-D7FD-E770-A625DEA729DC}"/>
                    </a:ext>
                  </a:extLst>
                </p:cNvPr>
                <p:cNvSpPr txBox="1"/>
                <p:nvPr/>
              </p:nvSpPr>
              <p:spPr>
                <a:xfrm rot="16200000">
                  <a:off x="4674677" y="409838"/>
                  <a:ext cx="230518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373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7735011D-7860-62F5-F7AC-5E2ED2AB6BA9}"/>
                    </a:ext>
                  </a:extLst>
                </p:cNvPr>
                <p:cNvSpPr txBox="1"/>
                <p:nvPr/>
              </p:nvSpPr>
              <p:spPr>
                <a:xfrm rot="16200000">
                  <a:off x="4177694" y="271971"/>
                  <a:ext cx="489344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aPaCa-2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68B56838-88A9-B86A-4069-780A84AD18EF}"/>
                    </a:ext>
                  </a:extLst>
                </p:cNvPr>
                <p:cNvSpPr txBox="1"/>
                <p:nvPr/>
              </p:nvSpPr>
              <p:spPr>
                <a:xfrm rot="16200000">
                  <a:off x="4834565" y="409838"/>
                  <a:ext cx="230518" cy="14625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343</a:t>
                  </a:r>
                </a:p>
              </p:txBody>
            </p:sp>
          </p:grp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89FD3943-9CA3-32FC-F0A7-778BE4AC406B}"/>
                  </a:ext>
                </a:extLst>
              </p:cNvPr>
              <p:cNvSpPr txBox="1"/>
              <p:nvPr/>
            </p:nvSpPr>
            <p:spPr>
              <a:xfrm>
                <a:off x="5128399" y="6807814"/>
                <a:ext cx="340509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50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CE9F9558-1FEA-01DF-D054-8FF2BC786964}"/>
                  </a:ext>
                </a:extLst>
              </p:cNvPr>
              <p:cNvSpPr txBox="1"/>
              <p:nvPr/>
            </p:nvSpPr>
            <p:spPr>
              <a:xfrm>
                <a:off x="5128399" y="6989847"/>
                <a:ext cx="340509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0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068140D0-C04D-8377-A687-1791B0FCA8C9}"/>
                  </a:ext>
                </a:extLst>
              </p:cNvPr>
              <p:cNvSpPr txBox="1"/>
              <p:nvPr/>
            </p:nvSpPr>
            <p:spPr>
              <a:xfrm>
                <a:off x="5124565" y="7182723"/>
                <a:ext cx="340509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671539BF-01E2-C0F5-29D9-15C0677E2EDD}"/>
                  </a:ext>
                </a:extLst>
              </p:cNvPr>
              <p:cNvSpPr txBox="1"/>
              <p:nvPr/>
            </p:nvSpPr>
            <p:spPr>
              <a:xfrm>
                <a:off x="5140248" y="7326262"/>
                <a:ext cx="275758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75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86186E1C-B8C1-796E-AEF1-5B6D2A3E1704}"/>
                  </a:ext>
                </a:extLst>
              </p:cNvPr>
              <p:cNvSpPr txBox="1"/>
              <p:nvPr/>
            </p:nvSpPr>
            <p:spPr>
              <a:xfrm>
                <a:off x="5165399" y="7563490"/>
                <a:ext cx="275758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50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6862D260-6CF5-0C0B-6CF5-8778BFFC31AF}"/>
                  </a:ext>
                </a:extLst>
              </p:cNvPr>
              <p:cNvSpPr txBox="1"/>
              <p:nvPr/>
            </p:nvSpPr>
            <p:spPr>
              <a:xfrm>
                <a:off x="5165399" y="7792525"/>
                <a:ext cx="275758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7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74B3E0D-2063-23AD-AFE0-00BD579063B9}"/>
                  </a:ext>
                </a:extLst>
              </p:cNvPr>
              <p:cNvSpPr txBox="1"/>
              <p:nvPr/>
            </p:nvSpPr>
            <p:spPr>
              <a:xfrm>
                <a:off x="5165399" y="8021560"/>
                <a:ext cx="275758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5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8C67B48-5319-D516-5802-67376FFC3F0A}"/>
                  </a:ext>
                </a:extLst>
              </p:cNvPr>
              <p:cNvSpPr txBox="1"/>
              <p:nvPr/>
            </p:nvSpPr>
            <p:spPr>
              <a:xfrm>
                <a:off x="5157718" y="8193544"/>
                <a:ext cx="275758" cy="1747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0</a:t>
                </a:r>
              </a:p>
            </p:txBody>
          </p:sp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329BDC21-A829-1AD8-2A2E-313437129E4A}"/>
                </a:ext>
              </a:extLst>
            </p:cNvPr>
            <p:cNvGrpSpPr/>
            <p:nvPr/>
          </p:nvGrpSpPr>
          <p:grpSpPr>
            <a:xfrm>
              <a:off x="9301878" y="6490736"/>
              <a:ext cx="4805905" cy="3395764"/>
              <a:chOff x="9505189" y="350601"/>
              <a:chExt cx="4805905" cy="3395764"/>
            </a:xfrm>
          </p:grpSpPr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BE4BEE28-B3F0-CA35-63F7-08D247603BB8}"/>
                  </a:ext>
                </a:extLst>
              </p:cNvPr>
              <p:cNvGrpSpPr/>
              <p:nvPr/>
            </p:nvGrpSpPr>
            <p:grpSpPr>
              <a:xfrm>
                <a:off x="9870525" y="1257380"/>
                <a:ext cx="4440569" cy="2389515"/>
                <a:chOff x="6965187" y="777086"/>
                <a:chExt cx="3734328" cy="1316025"/>
              </a:xfrm>
            </p:grpSpPr>
            <p:pic>
              <p:nvPicPr>
                <p:cNvPr id="140" name="Picture 139">
                  <a:extLst>
                    <a:ext uri="{FF2B5EF4-FFF2-40B4-BE49-F238E27FC236}">
                      <a16:creationId xmlns:a16="http://schemas.microsoft.com/office/drawing/2014/main" id="{8775D3EC-0CC6-EFFF-FD04-70BD95FD47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775" t="34753" r="20752" b="29778"/>
                <a:stretch/>
              </p:blipFill>
              <p:spPr>
                <a:xfrm>
                  <a:off x="6965187" y="777086"/>
                  <a:ext cx="2626065" cy="1316025"/>
                </a:xfrm>
                <a:prstGeom prst="rect">
                  <a:avLst/>
                </a:prstGeom>
              </p:spPr>
            </p:pic>
            <p:sp>
              <p:nvSpPr>
                <p:cNvPr id="141" name="Rectangle 140">
                  <a:extLst>
                    <a:ext uri="{FF2B5EF4-FFF2-40B4-BE49-F238E27FC236}">
                      <a16:creationId xmlns:a16="http://schemas.microsoft.com/office/drawing/2014/main" id="{004B7A05-4F28-45FD-9241-C700727C15FD}"/>
                    </a:ext>
                  </a:extLst>
                </p:cNvPr>
                <p:cNvSpPr/>
                <p:nvPr/>
              </p:nvSpPr>
              <p:spPr>
                <a:xfrm>
                  <a:off x="7312914" y="1455759"/>
                  <a:ext cx="1566325" cy="239034"/>
                </a:xfrm>
                <a:prstGeom prst="rect">
                  <a:avLst/>
                </a:pr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just"/>
                  <a:endPara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2" name="Group 141">
                  <a:extLst>
                    <a:ext uri="{FF2B5EF4-FFF2-40B4-BE49-F238E27FC236}">
                      <a16:creationId xmlns:a16="http://schemas.microsoft.com/office/drawing/2014/main" id="{ECC764C5-BB12-18F8-8C28-C6A57BA14A12}"/>
                    </a:ext>
                  </a:extLst>
                </p:cNvPr>
                <p:cNvGrpSpPr/>
                <p:nvPr/>
              </p:nvGrpSpPr>
              <p:grpSpPr>
                <a:xfrm>
                  <a:off x="9656891" y="1575276"/>
                  <a:ext cx="1042624" cy="152557"/>
                  <a:chOff x="9995557" y="1507543"/>
                  <a:chExt cx="1042624" cy="152557"/>
                </a:xfrm>
              </p:grpSpPr>
              <p:sp>
                <p:nvSpPr>
                  <p:cNvPr id="143" name="Isosceles Triangle 142">
                    <a:extLst>
                      <a:ext uri="{FF2B5EF4-FFF2-40B4-BE49-F238E27FC236}">
                        <a16:creationId xmlns:a16="http://schemas.microsoft.com/office/drawing/2014/main" id="{87162FFC-CDDC-8C7A-E4AD-4479DD6F2D33}"/>
                      </a:ext>
                    </a:extLst>
                  </p:cNvPr>
                  <p:cNvSpPr/>
                  <p:nvPr/>
                </p:nvSpPr>
                <p:spPr>
                  <a:xfrm rot="16373579">
                    <a:off x="10022574" y="1513080"/>
                    <a:ext cx="83544" cy="137577"/>
                  </a:xfrm>
                  <a:prstGeom prst="triangle">
                    <a:avLst/>
                  </a:prstGeom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 b="1"/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FC135995-8B99-57EF-2BC2-9E0455482B76}"/>
                      </a:ext>
                    </a:extLst>
                  </p:cNvPr>
                  <p:cNvSpPr txBox="1"/>
                  <p:nvPr/>
                </p:nvSpPr>
                <p:spPr>
                  <a:xfrm>
                    <a:off x="10119548" y="1507543"/>
                    <a:ext cx="918633" cy="152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36 </a:t>
                    </a:r>
                    <a:r>
                      <a:rPr lang="en-US" sz="1200" b="1" dirty="0" err="1"/>
                      <a:t>kDa</a:t>
                    </a:r>
                    <a:endParaRPr lang="en-US" sz="1200" b="1" dirty="0"/>
                  </a:p>
                </p:txBody>
              </p:sp>
            </p:grpSp>
          </p:grpSp>
          <p:grpSp>
            <p:nvGrpSpPr>
              <p:cNvPr id="119" name="Group 118">
                <a:extLst>
                  <a:ext uri="{FF2B5EF4-FFF2-40B4-BE49-F238E27FC236}">
                    <a16:creationId xmlns:a16="http://schemas.microsoft.com/office/drawing/2014/main" id="{FC59DF44-0F28-B0DF-C07E-157DB771C17F}"/>
                  </a:ext>
                </a:extLst>
              </p:cNvPr>
              <p:cNvGrpSpPr/>
              <p:nvPr/>
            </p:nvGrpSpPr>
            <p:grpSpPr>
              <a:xfrm>
                <a:off x="10290775" y="350601"/>
                <a:ext cx="1858558" cy="816217"/>
                <a:chOff x="3888069" y="134079"/>
                <a:chExt cx="1436941" cy="449532"/>
              </a:xfrm>
            </p:grpSpPr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66B509D5-EDB6-1FE4-E9CF-DBA5B40EA610}"/>
                    </a:ext>
                  </a:extLst>
                </p:cNvPr>
                <p:cNvSpPr txBox="1"/>
                <p:nvPr/>
              </p:nvSpPr>
              <p:spPr>
                <a:xfrm rot="16200000">
                  <a:off x="3835415" y="379518"/>
                  <a:ext cx="248082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299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873C6FCA-1C2C-4A31-B92E-DCC548776CCA}"/>
                    </a:ext>
                  </a:extLst>
                </p:cNvPr>
                <p:cNvSpPr txBox="1"/>
                <p:nvPr/>
              </p:nvSpPr>
              <p:spPr>
                <a:xfrm rot="16200000">
                  <a:off x="3987002" y="379518"/>
                  <a:ext cx="248082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2058</a:t>
                  </a:r>
                </a:p>
              </p:txBody>
            </p:sp>
            <p:sp>
              <p:nvSpPr>
                <p:cNvPr id="133" name="TextBox 132">
                  <a:extLst>
                    <a:ext uri="{FF2B5EF4-FFF2-40B4-BE49-F238E27FC236}">
                      <a16:creationId xmlns:a16="http://schemas.microsoft.com/office/drawing/2014/main" id="{35821C3A-96B6-C97C-B3D1-A1457198D14F}"/>
                    </a:ext>
                  </a:extLst>
                </p:cNvPr>
                <p:cNvSpPr txBox="1"/>
                <p:nvPr/>
              </p:nvSpPr>
              <p:spPr>
                <a:xfrm rot="16200000">
                  <a:off x="4112544" y="344253"/>
                  <a:ext cx="300170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C-1</a:t>
                  </a: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D7F085AF-E7FE-4F7C-D6A8-0B97F52E06D3}"/>
                    </a:ext>
                  </a:extLst>
                </p:cNvPr>
                <p:cNvSpPr txBox="1"/>
                <p:nvPr/>
              </p:nvSpPr>
              <p:spPr>
                <a:xfrm rot="16200000">
                  <a:off x="4988423" y="408373"/>
                  <a:ext cx="207471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i36</a:t>
                  </a:r>
                </a:p>
              </p:txBody>
            </p: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E182648B-F7F9-9E28-FAF1-54E48192EA63}"/>
                    </a:ext>
                  </a:extLst>
                </p:cNvPr>
                <p:cNvSpPr txBox="1"/>
                <p:nvPr/>
              </p:nvSpPr>
              <p:spPr>
                <a:xfrm rot="16200000">
                  <a:off x="5069547" y="318020"/>
                  <a:ext cx="368151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LC-GFP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88F43548-E7B2-32FF-A9E0-C308FC49B977}"/>
                    </a:ext>
                  </a:extLst>
                </p:cNvPr>
                <p:cNvSpPr txBox="1"/>
                <p:nvPr/>
              </p:nvSpPr>
              <p:spPr>
                <a:xfrm rot="16200000">
                  <a:off x="4479462" y="376312"/>
                  <a:ext cx="253379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229</a:t>
                  </a:r>
                </a:p>
              </p:txBody>
            </p: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73B2CC7E-5A8E-3BB7-9384-FDA1F0598CFA}"/>
                    </a:ext>
                  </a:extLst>
                </p:cNvPr>
                <p:cNvSpPr txBox="1"/>
                <p:nvPr/>
              </p:nvSpPr>
              <p:spPr>
                <a:xfrm rot="16200000">
                  <a:off x="4689290" y="411579"/>
                  <a:ext cx="201291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373</a:t>
                  </a:r>
                </a:p>
              </p:txBody>
            </p:sp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EE4AA262-0970-B2E6-E50A-ACD89ADD51F4}"/>
                    </a:ext>
                  </a:extLst>
                </p:cNvPr>
                <p:cNvSpPr txBox="1"/>
                <p:nvPr/>
              </p:nvSpPr>
              <p:spPr>
                <a:xfrm rot="16200000">
                  <a:off x="4208715" y="276343"/>
                  <a:ext cx="427301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aPaCa-2</a:t>
                  </a:r>
                </a:p>
              </p:txBody>
            </p: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44E9F627-376D-6A4E-6340-EA6CC0B9C641}"/>
                    </a:ext>
                  </a:extLst>
                </p:cNvPr>
                <p:cNvSpPr txBox="1"/>
                <p:nvPr/>
              </p:nvSpPr>
              <p:spPr>
                <a:xfrm rot="16200000">
                  <a:off x="4849178" y="411579"/>
                  <a:ext cx="201291" cy="14277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t" anchorCtr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343</a:t>
                  </a:r>
                </a:p>
              </p:txBody>
            </p:sp>
          </p:grpSp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703D816E-1552-598E-8ADE-648CE98529A2}"/>
                  </a:ext>
                </a:extLst>
              </p:cNvPr>
              <p:cNvGrpSpPr/>
              <p:nvPr/>
            </p:nvGrpSpPr>
            <p:grpSpPr>
              <a:xfrm>
                <a:off x="9505189" y="1191300"/>
                <a:ext cx="434418" cy="2555065"/>
                <a:chOff x="9545829" y="1186220"/>
                <a:chExt cx="434418" cy="2555065"/>
              </a:xfrm>
            </p:grpSpPr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A5B5B63B-6D15-2C4F-C6C4-B40E77C060A6}"/>
                    </a:ext>
                  </a:extLst>
                </p:cNvPr>
                <p:cNvSpPr txBox="1"/>
                <p:nvPr/>
              </p:nvSpPr>
              <p:spPr>
                <a:xfrm>
                  <a:off x="9550321" y="1186220"/>
                  <a:ext cx="429926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250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E0DA201E-1902-A546-235A-EB64C5C5D924}"/>
                    </a:ext>
                  </a:extLst>
                </p:cNvPr>
                <p:cNvSpPr txBox="1"/>
                <p:nvPr/>
              </p:nvSpPr>
              <p:spPr>
                <a:xfrm>
                  <a:off x="9550321" y="1485472"/>
                  <a:ext cx="429926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150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3180A6A4-A772-1DFB-56CA-1940FF605424}"/>
                    </a:ext>
                  </a:extLst>
                </p:cNvPr>
                <p:cNvSpPr txBox="1"/>
                <p:nvPr/>
              </p:nvSpPr>
              <p:spPr>
                <a:xfrm>
                  <a:off x="9545829" y="1802550"/>
                  <a:ext cx="429926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100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9E93E01B-054F-DC18-23F9-A31AD9964E7F}"/>
                    </a:ext>
                  </a:extLst>
                </p:cNvPr>
                <p:cNvSpPr txBox="1"/>
                <p:nvPr/>
              </p:nvSpPr>
              <p:spPr>
                <a:xfrm>
                  <a:off x="9564202" y="2038521"/>
                  <a:ext cx="348172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75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E85B8BC7-AAE4-F87A-656D-DF6ED8F72ECF}"/>
                    </a:ext>
                  </a:extLst>
                </p:cNvPr>
                <p:cNvSpPr txBox="1"/>
                <p:nvPr/>
              </p:nvSpPr>
              <p:spPr>
                <a:xfrm>
                  <a:off x="9593666" y="2428511"/>
                  <a:ext cx="348172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50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F81EFE9B-50C1-4E81-4827-41E6D4F5513C}"/>
                    </a:ext>
                  </a:extLst>
                </p:cNvPr>
                <p:cNvSpPr txBox="1"/>
                <p:nvPr/>
              </p:nvSpPr>
              <p:spPr>
                <a:xfrm>
                  <a:off x="9593666" y="2805033"/>
                  <a:ext cx="348172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37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BA53165E-3A6A-093A-C779-3CBC5B0AAFA4}"/>
                    </a:ext>
                  </a:extLst>
                </p:cNvPr>
                <p:cNvSpPr txBox="1"/>
                <p:nvPr/>
              </p:nvSpPr>
              <p:spPr>
                <a:xfrm>
                  <a:off x="9593666" y="3181554"/>
                  <a:ext cx="348172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25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CF03BD57-AAA9-8000-8FD8-3BA4B14D2944}"/>
                    </a:ext>
                  </a:extLst>
                </p:cNvPr>
                <p:cNvSpPr txBox="1"/>
                <p:nvPr/>
              </p:nvSpPr>
              <p:spPr>
                <a:xfrm>
                  <a:off x="9584668" y="3464287"/>
                  <a:ext cx="348172" cy="276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20</a:t>
                  </a:r>
                </a:p>
              </p:txBody>
            </p:sp>
          </p:grpSp>
        </p:grpSp>
      </p:grpSp>
      <p:sp>
        <p:nvSpPr>
          <p:cNvPr id="147" name="TextBox 146">
            <a:extLst>
              <a:ext uri="{FF2B5EF4-FFF2-40B4-BE49-F238E27FC236}">
                <a16:creationId xmlns:a16="http://schemas.microsoft.com/office/drawing/2014/main" id="{F0DDA637-E77D-08DF-37C8-435C7524B606}"/>
              </a:ext>
            </a:extLst>
          </p:cNvPr>
          <p:cNvSpPr txBox="1"/>
          <p:nvPr/>
        </p:nvSpPr>
        <p:spPr>
          <a:xfrm>
            <a:off x="602697" y="1068826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7CFB863F-DF8E-A501-3219-CF933D540588}"/>
              </a:ext>
            </a:extLst>
          </p:cNvPr>
          <p:cNvSpPr txBox="1"/>
          <p:nvPr/>
        </p:nvSpPr>
        <p:spPr>
          <a:xfrm>
            <a:off x="7178914" y="10904744"/>
            <a:ext cx="66553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 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threonine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36 (pT636-Hsp70)</a:t>
            </a:r>
          </a:p>
          <a:p>
            <a:pPr algn="just"/>
            <a:endParaRPr 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4A8A9A53-5771-04B0-FD23-0AA7261470F1}"/>
              </a:ext>
            </a:extLst>
          </p:cNvPr>
          <p:cNvGrpSpPr/>
          <p:nvPr/>
        </p:nvGrpSpPr>
        <p:grpSpPr>
          <a:xfrm>
            <a:off x="437513" y="11928408"/>
            <a:ext cx="6330127" cy="3079283"/>
            <a:chOff x="410857" y="11461825"/>
            <a:chExt cx="6330127" cy="3079283"/>
          </a:xfrm>
        </p:grpSpPr>
        <p:grpSp>
          <p:nvGrpSpPr>
            <p:cNvPr id="198" name="Group 197">
              <a:extLst>
                <a:ext uri="{FF2B5EF4-FFF2-40B4-BE49-F238E27FC236}">
                  <a16:creationId xmlns:a16="http://schemas.microsoft.com/office/drawing/2014/main" id="{F170DA53-490A-346D-F462-3F2B28EC3E40}"/>
                </a:ext>
              </a:extLst>
            </p:cNvPr>
            <p:cNvGrpSpPr/>
            <p:nvPr/>
          </p:nvGrpSpPr>
          <p:grpSpPr>
            <a:xfrm>
              <a:off x="410857" y="11461825"/>
              <a:ext cx="5142814" cy="3079283"/>
              <a:chOff x="410857" y="11461825"/>
              <a:chExt cx="5142814" cy="3079283"/>
            </a:xfrm>
          </p:grpSpPr>
          <p:grpSp>
            <p:nvGrpSpPr>
              <p:cNvPr id="148" name="Group 147">
                <a:extLst>
                  <a:ext uri="{FF2B5EF4-FFF2-40B4-BE49-F238E27FC236}">
                    <a16:creationId xmlns:a16="http://schemas.microsoft.com/office/drawing/2014/main" id="{AEFFB454-8054-D4F0-FC0B-8010A905BDE9}"/>
                  </a:ext>
                </a:extLst>
              </p:cNvPr>
              <p:cNvGrpSpPr/>
              <p:nvPr/>
            </p:nvGrpSpPr>
            <p:grpSpPr>
              <a:xfrm>
                <a:off x="410857" y="11461825"/>
                <a:ext cx="4850472" cy="3079283"/>
                <a:chOff x="3097803" y="6325410"/>
                <a:chExt cx="4850472" cy="3079283"/>
              </a:xfrm>
            </p:grpSpPr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24992878-F099-80B3-9C3A-BE3040824738}"/>
                    </a:ext>
                  </a:extLst>
                </p:cNvPr>
                <p:cNvSpPr txBox="1"/>
                <p:nvPr/>
              </p:nvSpPr>
              <p:spPr>
                <a:xfrm rot="16200000">
                  <a:off x="5683276" y="6715140"/>
                  <a:ext cx="964125" cy="18466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just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fPac1- Luc</a:t>
                  </a:r>
                </a:p>
              </p:txBody>
            </p:sp>
            <p:grpSp>
              <p:nvGrpSpPr>
                <p:cNvPr id="170" name="Group 169">
                  <a:extLst>
                    <a:ext uri="{FF2B5EF4-FFF2-40B4-BE49-F238E27FC236}">
                      <a16:creationId xmlns:a16="http://schemas.microsoft.com/office/drawing/2014/main" id="{C76C7DC4-C3CC-5D20-7850-768AAD9587D4}"/>
                    </a:ext>
                  </a:extLst>
                </p:cNvPr>
                <p:cNvGrpSpPr/>
                <p:nvPr/>
              </p:nvGrpSpPr>
              <p:grpSpPr>
                <a:xfrm>
                  <a:off x="3097803" y="6452476"/>
                  <a:ext cx="4850472" cy="2952217"/>
                  <a:chOff x="3097803" y="6452476"/>
                  <a:chExt cx="4850472" cy="2952217"/>
                </a:xfrm>
              </p:grpSpPr>
              <p:pic>
                <p:nvPicPr>
                  <p:cNvPr id="171" name="Picture 170">
                    <a:extLst>
                      <a:ext uri="{FF2B5EF4-FFF2-40B4-BE49-F238E27FC236}">
                        <a16:creationId xmlns:a16="http://schemas.microsoft.com/office/drawing/2014/main" id="{B00903AA-48C2-7596-ABAA-D709C5E2670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337" t="30393" r="24786" b="43027"/>
                  <a:stretch/>
                </p:blipFill>
                <p:spPr>
                  <a:xfrm>
                    <a:off x="3486881" y="7386544"/>
                    <a:ext cx="4461394" cy="2018149"/>
                  </a:xfrm>
                  <a:prstGeom prst="rect">
                    <a:avLst/>
                  </a:prstGeom>
                </p:spPr>
              </p:pic>
              <p:sp>
                <p:nvSpPr>
                  <p:cNvPr id="172" name="TextBox 171">
                    <a:extLst>
                      <a:ext uri="{FF2B5EF4-FFF2-40B4-BE49-F238E27FC236}">
                        <a16:creationId xmlns:a16="http://schemas.microsoft.com/office/drawing/2014/main" id="{7B21594B-40F2-9705-3E52-F11AC2A6856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660532" y="7004285"/>
                    <a:ext cx="376706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pPr algn="just"/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i36</a:t>
                    </a:r>
                  </a:p>
                </p:txBody>
              </p:sp>
              <p:sp>
                <p:nvSpPr>
                  <p:cNvPr id="173" name="TextBox 172">
                    <a:extLst>
                      <a:ext uri="{FF2B5EF4-FFF2-40B4-BE49-F238E27FC236}">
                        <a16:creationId xmlns:a16="http://schemas.microsoft.com/office/drawing/2014/main" id="{B2617DB9-4869-0E09-6707-5D238D5BE79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6675258" y="6966078"/>
                    <a:ext cx="365485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pPr algn="just"/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373</a:t>
                    </a:r>
                  </a:p>
                </p:txBody>
              </p:sp>
              <p:sp>
                <p:nvSpPr>
                  <p:cNvPr id="174" name="TextBox 173">
                    <a:extLst>
                      <a:ext uri="{FF2B5EF4-FFF2-40B4-BE49-F238E27FC236}">
                        <a16:creationId xmlns:a16="http://schemas.microsoft.com/office/drawing/2014/main" id="{7E3D81B8-B4AF-1340-7700-D48BC7A1E42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6124622" y="6754482"/>
                    <a:ext cx="788677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pPr algn="just"/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LC-GGFP</a:t>
                    </a:r>
                  </a:p>
                </p:txBody>
              </p:sp>
              <p:grpSp>
                <p:nvGrpSpPr>
                  <p:cNvPr id="175" name="Group 174">
                    <a:extLst>
                      <a:ext uri="{FF2B5EF4-FFF2-40B4-BE49-F238E27FC236}">
                        <a16:creationId xmlns:a16="http://schemas.microsoft.com/office/drawing/2014/main" id="{35AAE0AA-FEAB-F82E-E1C1-2A60733A6859}"/>
                      </a:ext>
                    </a:extLst>
                  </p:cNvPr>
                  <p:cNvGrpSpPr/>
                  <p:nvPr/>
                </p:nvGrpSpPr>
                <p:grpSpPr>
                  <a:xfrm>
                    <a:off x="3097803" y="7349452"/>
                    <a:ext cx="434901" cy="2007864"/>
                    <a:chOff x="492583" y="1775110"/>
                    <a:chExt cx="434901" cy="2007864"/>
                  </a:xfrm>
                </p:grpSpPr>
                <p:sp>
                  <p:nvSpPr>
                    <p:cNvPr id="177" name="TextBox 176">
                      <a:extLst>
                        <a:ext uri="{FF2B5EF4-FFF2-40B4-BE49-F238E27FC236}">
                          <a16:creationId xmlns:a16="http://schemas.microsoft.com/office/drawing/2014/main" id="{1C7D16F4-C8DF-8BD6-2548-A00FA8D634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558" y="1775110"/>
                      <a:ext cx="42992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250</a:t>
                      </a:r>
                    </a:p>
                  </p:txBody>
                </p:sp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id="{B2E7E9BD-23BA-0C3B-34E8-BF8B8D78DB8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558" y="2123361"/>
                      <a:ext cx="42992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50</a:t>
                      </a:r>
                    </a:p>
                  </p:txBody>
                </p:sp>
                <p:sp>
                  <p:nvSpPr>
                    <p:cNvPr id="179" name="TextBox 178">
                      <a:extLst>
                        <a:ext uri="{FF2B5EF4-FFF2-40B4-BE49-F238E27FC236}">
                          <a16:creationId xmlns:a16="http://schemas.microsoft.com/office/drawing/2014/main" id="{B69D8752-4FB1-F1AA-CA16-299252C7F5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2583" y="2444123"/>
                      <a:ext cx="42992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00</a:t>
                      </a:r>
                    </a:p>
                  </p:txBody>
                </p:sp>
                <p:sp>
                  <p:nvSpPr>
                    <p:cNvPr id="180" name="TextBox 179">
                      <a:extLst>
                        <a:ext uri="{FF2B5EF4-FFF2-40B4-BE49-F238E27FC236}">
                          <a16:creationId xmlns:a16="http://schemas.microsoft.com/office/drawing/2014/main" id="{64B35371-05A1-DD18-E213-53B7329CE3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2933" y="2675009"/>
                      <a:ext cx="34817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75</a:t>
                      </a:r>
                    </a:p>
                  </p:txBody>
                </p:sp>
                <p:sp>
                  <p:nvSpPr>
                    <p:cNvPr id="181" name="TextBox 180">
                      <a:extLst>
                        <a:ext uri="{FF2B5EF4-FFF2-40B4-BE49-F238E27FC236}">
                          <a16:creationId xmlns:a16="http://schemas.microsoft.com/office/drawing/2014/main" id="{733C870C-0AD4-3B35-D2E2-F37C17B11D4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5568" y="3166750"/>
                      <a:ext cx="34817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50</a:t>
                      </a:r>
                    </a:p>
                  </p:txBody>
                </p:sp>
                <p:sp>
                  <p:nvSpPr>
                    <p:cNvPr id="182" name="TextBox 181">
                      <a:extLst>
                        <a:ext uri="{FF2B5EF4-FFF2-40B4-BE49-F238E27FC236}">
                          <a16:creationId xmlns:a16="http://schemas.microsoft.com/office/drawing/2014/main" id="{5049F86E-B6F1-80EE-2141-CFDFCFE30C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5568" y="3505975"/>
                      <a:ext cx="34817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37</a:t>
                      </a:r>
                    </a:p>
                  </p:txBody>
                </p:sp>
              </p:grpSp>
              <p:sp>
                <p:nvSpPr>
                  <p:cNvPr id="176" name="Rectangle 175">
                    <a:extLst>
                      <a:ext uri="{FF2B5EF4-FFF2-40B4-BE49-F238E27FC236}">
                        <a16:creationId xmlns:a16="http://schemas.microsoft.com/office/drawing/2014/main" id="{183FCE13-C1FA-6601-51BD-561ED47A1BB1}"/>
                      </a:ext>
                    </a:extLst>
                  </p:cNvPr>
                  <p:cNvSpPr/>
                  <p:nvPr/>
                </p:nvSpPr>
                <p:spPr>
                  <a:xfrm>
                    <a:off x="5514183" y="8243464"/>
                    <a:ext cx="1585117" cy="254568"/>
                  </a:xfrm>
                  <a:prstGeom prst="rect">
                    <a:avLst/>
                  </a:prstGeom>
                  <a:noFill/>
                  <a:ln w="2540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just"/>
                    <a:endParaRPr lang="en-US" sz="1200" b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51" name="Isosceles Triangle 150">
                <a:extLst>
                  <a:ext uri="{FF2B5EF4-FFF2-40B4-BE49-F238E27FC236}">
                    <a16:creationId xmlns:a16="http://schemas.microsoft.com/office/drawing/2014/main" id="{3931AD81-C856-CB4E-4C7B-73993CDADA84}"/>
                  </a:ext>
                </a:extLst>
              </p:cNvPr>
              <p:cNvSpPr/>
              <p:nvPr/>
            </p:nvSpPr>
            <p:spPr>
              <a:xfrm rot="16373579">
                <a:off x="5399070" y="13497703"/>
                <a:ext cx="130686" cy="178516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/>
              </a:p>
            </p:txBody>
          </p:sp>
        </p:grp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2BFE635D-3D7E-1619-27E6-733B0E677150}"/>
                </a:ext>
              </a:extLst>
            </p:cNvPr>
            <p:cNvSpPr txBox="1"/>
            <p:nvPr/>
          </p:nvSpPr>
          <p:spPr>
            <a:xfrm>
              <a:off x="5548989" y="13459677"/>
              <a:ext cx="119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7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</p:grpSp>
      <p:sp>
        <p:nvSpPr>
          <p:cNvPr id="157" name="TextBox 156">
            <a:extLst>
              <a:ext uri="{FF2B5EF4-FFF2-40B4-BE49-F238E27FC236}">
                <a16:creationId xmlns:a16="http://schemas.microsoft.com/office/drawing/2014/main" id="{96984713-66E7-96FA-A252-A500399A1946}"/>
              </a:ext>
            </a:extLst>
          </p:cNvPr>
          <p:cNvSpPr txBox="1"/>
          <p:nvPr/>
        </p:nvSpPr>
        <p:spPr>
          <a:xfrm>
            <a:off x="1026297" y="10791154"/>
            <a:ext cx="59353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 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tyrosine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-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/>
            <a:endParaRPr lang="en-US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8407BD1-6CB9-35DD-30C3-14EC0782653E}"/>
              </a:ext>
            </a:extLst>
          </p:cNvPr>
          <p:cNvSpPr txBox="1"/>
          <p:nvPr/>
        </p:nvSpPr>
        <p:spPr>
          <a:xfrm>
            <a:off x="1817462" y="1941102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85" name="Right Bracket 184">
            <a:extLst>
              <a:ext uri="{FF2B5EF4-FFF2-40B4-BE49-F238E27FC236}">
                <a16:creationId xmlns:a16="http://schemas.microsoft.com/office/drawing/2014/main" id="{D7CD1048-D12F-C5E0-46C5-2CE286706897}"/>
              </a:ext>
            </a:extLst>
          </p:cNvPr>
          <p:cNvSpPr/>
          <p:nvPr/>
        </p:nvSpPr>
        <p:spPr>
          <a:xfrm rot="5400000" flipH="1">
            <a:off x="2325172" y="823142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3FC3377-87F3-ADB1-C875-22ACFF516795}"/>
              </a:ext>
            </a:extLst>
          </p:cNvPr>
          <p:cNvSpPr txBox="1"/>
          <p:nvPr/>
        </p:nvSpPr>
        <p:spPr>
          <a:xfrm>
            <a:off x="6515302" y="1941102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87" name="Right Bracket 186">
            <a:extLst>
              <a:ext uri="{FF2B5EF4-FFF2-40B4-BE49-F238E27FC236}">
                <a16:creationId xmlns:a16="http://schemas.microsoft.com/office/drawing/2014/main" id="{12DB2290-D8E9-C1CD-AF32-D05DC7C4A7BC}"/>
              </a:ext>
            </a:extLst>
          </p:cNvPr>
          <p:cNvSpPr/>
          <p:nvPr/>
        </p:nvSpPr>
        <p:spPr>
          <a:xfrm rot="5400000" flipH="1">
            <a:off x="6916718" y="823142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B1DF4433-55BA-915B-A2D5-5A259596E160}"/>
              </a:ext>
            </a:extLst>
          </p:cNvPr>
          <p:cNvSpPr txBox="1"/>
          <p:nvPr/>
        </p:nvSpPr>
        <p:spPr>
          <a:xfrm>
            <a:off x="10879004" y="1897853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89" name="Right Bracket 188">
            <a:extLst>
              <a:ext uri="{FF2B5EF4-FFF2-40B4-BE49-F238E27FC236}">
                <a16:creationId xmlns:a16="http://schemas.microsoft.com/office/drawing/2014/main" id="{0B635FF1-381D-02EB-9B8B-3447FE1FDDAA}"/>
              </a:ext>
            </a:extLst>
          </p:cNvPr>
          <p:cNvSpPr/>
          <p:nvPr/>
        </p:nvSpPr>
        <p:spPr>
          <a:xfrm rot="5400000" flipH="1">
            <a:off x="11409682" y="823142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98B7B51D-6DA0-27DA-7306-9DCD608C6B3B}"/>
              </a:ext>
            </a:extLst>
          </p:cNvPr>
          <p:cNvSpPr txBox="1"/>
          <p:nvPr/>
        </p:nvSpPr>
        <p:spPr>
          <a:xfrm>
            <a:off x="2071713" y="6651954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92" name="Right Bracket 191">
            <a:extLst>
              <a:ext uri="{FF2B5EF4-FFF2-40B4-BE49-F238E27FC236}">
                <a16:creationId xmlns:a16="http://schemas.microsoft.com/office/drawing/2014/main" id="{B4FA88E2-4F29-4457-3F2C-FDDDABFC00F1}"/>
              </a:ext>
            </a:extLst>
          </p:cNvPr>
          <p:cNvSpPr/>
          <p:nvPr/>
        </p:nvSpPr>
        <p:spPr>
          <a:xfrm rot="5400000" flipH="1">
            <a:off x="2579423" y="5533994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9F0860CB-8018-3253-DC51-6E6D8704FE4C}"/>
              </a:ext>
            </a:extLst>
          </p:cNvPr>
          <p:cNvSpPr txBox="1"/>
          <p:nvPr/>
        </p:nvSpPr>
        <p:spPr>
          <a:xfrm>
            <a:off x="6415131" y="6647801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94" name="Right Bracket 193">
            <a:extLst>
              <a:ext uri="{FF2B5EF4-FFF2-40B4-BE49-F238E27FC236}">
                <a16:creationId xmlns:a16="http://schemas.microsoft.com/office/drawing/2014/main" id="{2487BC85-F208-6CE1-7A9E-C2FBBF5FFDEC}"/>
              </a:ext>
            </a:extLst>
          </p:cNvPr>
          <p:cNvSpPr/>
          <p:nvPr/>
        </p:nvSpPr>
        <p:spPr>
          <a:xfrm rot="5400000" flipH="1">
            <a:off x="6922841" y="5529841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85537EA1-10F2-CACF-74D6-BC32424D1B0A}"/>
              </a:ext>
            </a:extLst>
          </p:cNvPr>
          <p:cNvSpPr txBox="1"/>
          <p:nvPr/>
        </p:nvSpPr>
        <p:spPr>
          <a:xfrm>
            <a:off x="10901972" y="6593805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96" name="Right Bracket 195">
            <a:extLst>
              <a:ext uri="{FF2B5EF4-FFF2-40B4-BE49-F238E27FC236}">
                <a16:creationId xmlns:a16="http://schemas.microsoft.com/office/drawing/2014/main" id="{4354C98E-7520-4CF2-5A88-30193F366FD7}"/>
              </a:ext>
            </a:extLst>
          </p:cNvPr>
          <p:cNvSpPr/>
          <p:nvPr/>
        </p:nvSpPr>
        <p:spPr>
          <a:xfrm rot="5400000" flipH="1">
            <a:off x="11409682" y="5475845"/>
            <a:ext cx="89863" cy="2949643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6D80C038-6C6F-65A6-2EE7-5FB085BC5063}"/>
              </a:ext>
            </a:extLst>
          </p:cNvPr>
          <p:cNvSpPr txBox="1"/>
          <p:nvPr/>
        </p:nvSpPr>
        <p:spPr>
          <a:xfrm>
            <a:off x="3412262" y="11349012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 defTabSz="121924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MD-CM</a:t>
            </a:r>
          </a:p>
        </p:txBody>
      </p:sp>
      <p:sp>
        <p:nvSpPr>
          <p:cNvPr id="201" name="Right Bracket 200">
            <a:extLst>
              <a:ext uri="{FF2B5EF4-FFF2-40B4-BE49-F238E27FC236}">
                <a16:creationId xmlns:a16="http://schemas.microsoft.com/office/drawing/2014/main" id="{5F7DA6BF-B426-CFA7-B823-A863A219FB0A}"/>
              </a:ext>
            </a:extLst>
          </p:cNvPr>
          <p:cNvSpPr/>
          <p:nvPr/>
        </p:nvSpPr>
        <p:spPr>
          <a:xfrm rot="5400000" flipH="1">
            <a:off x="3797273" y="10970035"/>
            <a:ext cx="57612" cy="1436671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just"/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2D23A232-CDF3-1EB9-74B1-4BC5BF637126}"/>
              </a:ext>
            </a:extLst>
          </p:cNvPr>
          <p:cNvGrpSpPr/>
          <p:nvPr/>
        </p:nvGrpSpPr>
        <p:grpSpPr>
          <a:xfrm>
            <a:off x="7099759" y="11502657"/>
            <a:ext cx="6229817" cy="3440060"/>
            <a:chOff x="6996109" y="11574779"/>
            <a:chExt cx="6229817" cy="3440060"/>
          </a:xfrm>
        </p:grpSpPr>
        <p:grpSp>
          <p:nvGrpSpPr>
            <p:cNvPr id="197" name="Group 196">
              <a:extLst>
                <a:ext uri="{FF2B5EF4-FFF2-40B4-BE49-F238E27FC236}">
                  <a16:creationId xmlns:a16="http://schemas.microsoft.com/office/drawing/2014/main" id="{C6BA5DDE-CB8A-D784-D5E7-119FBE0D87E1}"/>
                </a:ext>
              </a:extLst>
            </p:cNvPr>
            <p:cNvGrpSpPr/>
            <p:nvPr/>
          </p:nvGrpSpPr>
          <p:grpSpPr>
            <a:xfrm>
              <a:off x="6996109" y="11968752"/>
              <a:ext cx="6229817" cy="3046087"/>
              <a:chOff x="6993247" y="11372299"/>
              <a:chExt cx="6229817" cy="3046087"/>
            </a:xfrm>
          </p:grpSpPr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E043501A-24DE-145A-3D89-A1848639713E}"/>
                  </a:ext>
                </a:extLst>
              </p:cNvPr>
              <p:cNvGrpSpPr/>
              <p:nvPr/>
            </p:nvGrpSpPr>
            <p:grpSpPr>
              <a:xfrm>
                <a:off x="6993247" y="12311966"/>
                <a:ext cx="4787665" cy="2106420"/>
                <a:chOff x="3066753" y="9591739"/>
                <a:chExt cx="4787665" cy="2106420"/>
              </a:xfrm>
            </p:grpSpPr>
            <p:pic>
              <p:nvPicPr>
                <p:cNvPr id="161" name="Picture 160" descr="A close-up of a black and white photo&#10;&#10;Description automatically generated">
                  <a:extLst>
                    <a:ext uri="{FF2B5EF4-FFF2-40B4-BE49-F238E27FC236}">
                      <a16:creationId xmlns:a16="http://schemas.microsoft.com/office/drawing/2014/main" id="{49EFF80E-0E09-39C1-F94C-1727A447617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327" r="2103" b="4868"/>
                <a:stretch/>
              </p:blipFill>
              <p:spPr>
                <a:xfrm>
                  <a:off x="3486881" y="9709274"/>
                  <a:ext cx="4367537" cy="1988885"/>
                </a:xfrm>
                <a:prstGeom prst="rect">
                  <a:avLst/>
                </a:prstGeom>
              </p:spPr>
            </p:pic>
            <p:grpSp>
              <p:nvGrpSpPr>
                <p:cNvPr id="162" name="Group 161">
                  <a:extLst>
                    <a:ext uri="{FF2B5EF4-FFF2-40B4-BE49-F238E27FC236}">
                      <a16:creationId xmlns:a16="http://schemas.microsoft.com/office/drawing/2014/main" id="{8AD034BF-6AD0-ACE4-F674-7AC80AE089A0}"/>
                    </a:ext>
                  </a:extLst>
                </p:cNvPr>
                <p:cNvGrpSpPr/>
                <p:nvPr/>
              </p:nvGrpSpPr>
              <p:grpSpPr>
                <a:xfrm>
                  <a:off x="3066753" y="9591739"/>
                  <a:ext cx="434901" cy="2007864"/>
                  <a:chOff x="492583" y="1775110"/>
                  <a:chExt cx="434901" cy="2007864"/>
                </a:xfrm>
              </p:grpSpPr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331A12AC-0226-54A7-FB49-DFEF5FAB9FCD}"/>
                      </a:ext>
                    </a:extLst>
                  </p:cNvPr>
                  <p:cNvSpPr txBox="1"/>
                  <p:nvPr/>
                </p:nvSpPr>
                <p:spPr>
                  <a:xfrm>
                    <a:off x="497558" y="1775110"/>
                    <a:ext cx="4299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250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3485A591-4C8F-A746-EE4F-2B3E3F84F561}"/>
                      </a:ext>
                    </a:extLst>
                  </p:cNvPr>
                  <p:cNvSpPr txBox="1"/>
                  <p:nvPr/>
                </p:nvSpPr>
                <p:spPr>
                  <a:xfrm>
                    <a:off x="497558" y="2123361"/>
                    <a:ext cx="4299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50</a:t>
                    </a:r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3C3A65C1-1B3A-F8F7-024D-EB5D52A2AD2E}"/>
                      </a:ext>
                    </a:extLst>
                  </p:cNvPr>
                  <p:cNvSpPr txBox="1"/>
                  <p:nvPr/>
                </p:nvSpPr>
                <p:spPr>
                  <a:xfrm>
                    <a:off x="492583" y="2444123"/>
                    <a:ext cx="4299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00</a:t>
                    </a:r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392D7894-26C8-07E1-5787-EA2DE9F57EC1}"/>
                      </a:ext>
                    </a:extLst>
                  </p:cNvPr>
                  <p:cNvSpPr txBox="1"/>
                  <p:nvPr/>
                </p:nvSpPr>
                <p:spPr>
                  <a:xfrm>
                    <a:off x="512933" y="2675009"/>
                    <a:ext cx="34817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75</a:t>
                    </a:r>
                  </a:p>
                </p:txBody>
              </p:sp>
              <p:sp>
                <p:nvSpPr>
                  <p:cNvPr id="167" name="TextBox 166">
                    <a:extLst>
                      <a:ext uri="{FF2B5EF4-FFF2-40B4-BE49-F238E27FC236}">
                        <a16:creationId xmlns:a16="http://schemas.microsoft.com/office/drawing/2014/main" id="{9B2B16FC-5F14-B887-A198-9E4D73A33075}"/>
                      </a:ext>
                    </a:extLst>
                  </p:cNvPr>
                  <p:cNvSpPr txBox="1"/>
                  <p:nvPr/>
                </p:nvSpPr>
                <p:spPr>
                  <a:xfrm>
                    <a:off x="545568" y="3166750"/>
                    <a:ext cx="34817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50</a:t>
                    </a:r>
                  </a:p>
                </p:txBody>
              </p:sp>
              <p:sp>
                <p:nvSpPr>
                  <p:cNvPr id="168" name="TextBox 167">
                    <a:extLst>
                      <a:ext uri="{FF2B5EF4-FFF2-40B4-BE49-F238E27FC236}">
                        <a16:creationId xmlns:a16="http://schemas.microsoft.com/office/drawing/2014/main" id="{1AE851DB-D0D4-3F60-2AD1-FD94E3BD4CC8}"/>
                      </a:ext>
                    </a:extLst>
                  </p:cNvPr>
                  <p:cNvSpPr txBox="1"/>
                  <p:nvPr/>
                </p:nvSpPr>
                <p:spPr>
                  <a:xfrm>
                    <a:off x="545568" y="3505975"/>
                    <a:ext cx="34817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37</a:t>
                    </a:r>
                  </a:p>
                </p:txBody>
              </p:sp>
            </p:grpSp>
          </p:grp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D401783D-9D8F-2A6D-457C-2472A0A95A43}"/>
                  </a:ext>
                </a:extLst>
              </p:cNvPr>
              <p:cNvSpPr txBox="1"/>
              <p:nvPr/>
            </p:nvSpPr>
            <p:spPr>
              <a:xfrm rot="16200000">
                <a:off x="9564403" y="11762029"/>
                <a:ext cx="964125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fPac1- Luc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B40D457E-DCF2-2E0E-6285-F8553F87BFF6}"/>
                  </a:ext>
                </a:extLst>
              </p:cNvPr>
              <p:cNvSpPr txBox="1"/>
              <p:nvPr/>
            </p:nvSpPr>
            <p:spPr>
              <a:xfrm rot="16200000">
                <a:off x="9541659" y="12051174"/>
                <a:ext cx="376706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i36</a:t>
                </a: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18AB0C90-510D-D609-BB4B-ADC4AE1B2462}"/>
                  </a:ext>
                </a:extLst>
              </p:cNvPr>
              <p:cNvSpPr txBox="1"/>
              <p:nvPr/>
            </p:nvSpPr>
            <p:spPr>
              <a:xfrm rot="16200000">
                <a:off x="10556385" y="12012967"/>
                <a:ext cx="365485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373</a:t>
                </a: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328F0C05-C7B1-AEFC-D83E-465C9D1B1C7D}"/>
                  </a:ext>
                </a:extLst>
              </p:cNvPr>
              <p:cNvSpPr txBox="1"/>
              <p:nvPr/>
            </p:nvSpPr>
            <p:spPr>
              <a:xfrm rot="16200000">
                <a:off x="10005749" y="11801371"/>
                <a:ext cx="788677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LC-GGFP</a:t>
                </a:r>
              </a:p>
            </p:txBody>
          </p:sp>
          <p:sp>
            <p:nvSpPr>
              <p:cNvPr id="158" name="Isosceles Triangle 157">
                <a:extLst>
                  <a:ext uri="{FF2B5EF4-FFF2-40B4-BE49-F238E27FC236}">
                    <a16:creationId xmlns:a16="http://schemas.microsoft.com/office/drawing/2014/main" id="{FE1D743E-E18C-DEC6-DFCB-07DF71644199}"/>
                  </a:ext>
                </a:extLst>
              </p:cNvPr>
              <p:cNvSpPr/>
              <p:nvPr/>
            </p:nvSpPr>
            <p:spPr>
              <a:xfrm rot="16373579">
                <a:off x="11881150" y="13326364"/>
                <a:ext cx="130686" cy="178516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/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835F4956-9EEC-FBB2-27E9-66D4AB800D0B}"/>
                  </a:ext>
                </a:extLst>
              </p:cNvPr>
              <p:cNvSpPr txBox="1"/>
              <p:nvPr/>
            </p:nvSpPr>
            <p:spPr>
              <a:xfrm>
                <a:off x="12031069" y="13288338"/>
                <a:ext cx="1191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0 </a:t>
                </a:r>
                <a:r>
                  <a:rPr lang="en-US" sz="1200" b="1" dirty="0" err="1"/>
                  <a:t>kDa</a:t>
                </a:r>
                <a:endParaRPr lang="en-US" sz="1200" b="1" dirty="0"/>
              </a:p>
            </p:txBody>
          </p: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C0316B52-C7A0-0364-EEBB-A115CBA8D2DB}"/>
                  </a:ext>
                </a:extLst>
              </p:cNvPr>
              <p:cNvSpPr/>
              <p:nvPr/>
            </p:nvSpPr>
            <p:spPr>
              <a:xfrm>
                <a:off x="9533989" y="13238632"/>
                <a:ext cx="1397368" cy="246755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just"/>
                <a:endParaRPr lang="en-US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7A3A7BF3-3194-0646-B9A3-CFF0AB30DEFE}"/>
                </a:ext>
              </a:extLst>
            </p:cNvPr>
            <p:cNvSpPr txBox="1"/>
            <p:nvPr/>
          </p:nvSpPr>
          <p:spPr>
            <a:xfrm>
              <a:off x="9802066" y="11574779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 defTabSz="1219246">
                <a:defRPr/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MD-CM</a:t>
              </a:r>
            </a:p>
          </p:txBody>
        </p:sp>
        <p:sp>
          <p:nvSpPr>
            <p:cNvPr id="203" name="Right Bracket 202">
              <a:extLst>
                <a:ext uri="{FF2B5EF4-FFF2-40B4-BE49-F238E27FC236}">
                  <a16:creationId xmlns:a16="http://schemas.microsoft.com/office/drawing/2014/main" id="{729E4138-A074-37A2-20AD-9F9A7FB2C0D2}"/>
                </a:ext>
              </a:extLst>
            </p:cNvPr>
            <p:cNvSpPr/>
            <p:nvPr/>
          </p:nvSpPr>
          <p:spPr>
            <a:xfrm rot="5400000" flipH="1">
              <a:off x="10187079" y="11195802"/>
              <a:ext cx="57612" cy="1436671"/>
            </a:xfrm>
            <a:prstGeom prst="rightBracket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just"/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1588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41</TotalTime>
  <Words>385</Words>
  <Application>Microsoft Office PowerPoint</Application>
  <PresentationFormat>Custom</PresentationFormat>
  <Paragraphs>1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University of Cincinna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ynak, Ahmet (kaynakat)</dc:creator>
  <cp:lastModifiedBy>Kaynak, Ahmet (kaynakat)</cp:lastModifiedBy>
  <cp:revision>25</cp:revision>
  <cp:lastPrinted>2024-11-15T14:36:32Z</cp:lastPrinted>
  <dcterms:created xsi:type="dcterms:W3CDTF">2024-11-06T15:34:08Z</dcterms:created>
  <dcterms:modified xsi:type="dcterms:W3CDTF">2025-01-27T17:34:39Z</dcterms:modified>
</cp:coreProperties>
</file>